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3.xml.rels" ContentType="application/vnd.openxmlformats-package.relationships+xml"/>
  <Override PartName="/ppt/slideMasters/_rels/slideMaster2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_rels/notesSlide9.xml.rels" ContentType="application/vnd.openxmlformats-package.relationships+xml"/>
  <Override PartName="/ppt/notesSlides/_rels/notesSlide6.xml.rels" ContentType="application/vnd.openxmlformats-package.relationships+xml"/>
  <Override PartName="/ppt/notesSlides/_rels/notesSlide8.xml.rels" ContentType="application/vnd.openxmlformats-package.relationships+xml"/>
  <Override PartName="/ppt/notesSlides/_rels/notesSlide7.xml.rels" ContentType="application/vnd.openxmlformats-package.relationships+xml"/>
  <Override PartName="/ppt/notesSlides/_rels/notesSlide5.xml.rels" ContentType="application/vnd.openxmlformats-package.relationships+xml"/>
  <Override PartName="/ppt/notesSlides/_rels/notesSlide10.xml.rels" ContentType="application/vnd.openxmlformats-package.relationships+xml"/>
  <Override PartName="/ppt/notesSlides/_rels/notesSlide3.xml.rels" ContentType="application/vnd.openxmlformats-package.relationships+xml"/>
  <Override PartName="/ppt/notesSlides/_rels/notesSlide4.xml.rels" ContentType="application/vnd.openxmlformats-package.relationships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_rels/presentation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39.xml.rels" ContentType="application/vnd.openxmlformats-package.relationships+xml"/>
  <Override PartName="/ppt/slideLayouts/slideLayout29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5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28.png" ContentType="image/png"/>
  <Override PartName="/ppt/media/image4.png" ContentType="image/png"/>
  <Override PartName="/ppt/media/image27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</p:sldMasterIdLst>
  <p:notesMasterIdLst>
    <p:notesMasterId r:id="rId6"/>
  </p:notesMasterIdLst>
  <p:sldIdLst>
    <p:sldId id="256" r:id="rId7"/>
    <p:sldId id="257" r:id="rId8"/>
    <p:sldId id="258" r:id="rId9"/>
    <p:sldId id="259" r:id="rId10"/>
    <p:sldId id="260" r:id="rId11"/>
    <p:sldId id="261" r:id="rId12"/>
    <p:sldId id="262" r:id="rId13"/>
    <p:sldId id="263" r:id="rId14"/>
    <p:sldId id="264" r:id="rId15"/>
    <p:sldId id="265" r:id="rId1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notesMaster" Target="notesMasters/notesMaster1.xml"/><Relationship Id="rId7" Type="http://schemas.openxmlformats.org/officeDocument/2006/relationships/slide" Target="slides/slide1.xml"/><Relationship Id="rId8" Type="http://schemas.openxmlformats.org/officeDocument/2006/relationships/slide" Target="slides/slide2.xml"/><Relationship Id="rId9" Type="http://schemas.openxmlformats.org/officeDocument/2006/relationships/slide" Target="slides/slide3.xml"/><Relationship Id="rId10" Type="http://schemas.openxmlformats.org/officeDocument/2006/relationships/slide" Target="slides/slide4.xml"/><Relationship Id="rId11" Type="http://schemas.openxmlformats.org/officeDocument/2006/relationships/slide" Target="slides/slide5.xml"/><Relationship Id="rId12" Type="http://schemas.openxmlformats.org/officeDocument/2006/relationships/slide" Target="slides/slide6.xml"/><Relationship Id="rId13" Type="http://schemas.openxmlformats.org/officeDocument/2006/relationships/slide" Target="slides/slide7.xml"/><Relationship Id="rId14" Type="http://schemas.openxmlformats.org/officeDocument/2006/relationships/slide" Target="slides/slide8.xml"/><Relationship Id="rId15" Type="http://schemas.openxmlformats.org/officeDocument/2006/relationships/slide" Target="slides/slide9.xml"/><Relationship Id="rId16" Type="http://schemas.openxmlformats.org/officeDocument/2006/relationships/slide" Target="slides/slide10.xml"/><Relationship Id="rId1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5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PlaceHolder 2"/>
          <p:cNvSpPr>
            <a:spLocks noGrp="1"/>
          </p:cNvSpPr>
          <p:nvPr>
            <p:ph type="dt" idx="13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PlaceHolder 5"/>
          <p:cNvSpPr>
            <a:spLocks noGrp="1"/>
          </p:cNvSpPr>
          <p:nvPr>
            <p:ph type="ftr" idx="14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PlaceHolder 6"/>
          <p:cNvSpPr>
            <a:spLocks noGrp="1"/>
          </p:cNvSpPr>
          <p:nvPr>
            <p:ph type="sldNum" idx="15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546DCE6-CA2D-49AA-A6CF-C65A7CF8DFE2}" type="slidenum"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0.xml.rels><?xml version="1.0" encoding="UTF-8"?>
<Relationships xmlns="http://schemas.openxmlformats.org/package/2006/relationships"><Relationship Id="rId1" Type="http://schemas.openxmlformats.org/officeDocument/2006/relationships/slide" Target="../slides/slide10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9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08C65BC-5C25-4287-B3C6-58C3A25B1E4D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6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8243303-C322-4C3D-9B42-7174A71E0D74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7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3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68FBABE-EE86-433E-A7AE-83F89B3D23DC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7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FB2CD74-ED4D-41D8-A06F-9AFE91A6942A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7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5969EA9-2C17-4748-8444-D3E283C64491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8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A712115-E008-4E92-AE8B-3A42B0D0F943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8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5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DB90CCB-2B1E-42C3-B107-F6AC73323681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8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7A60F08-1140-44FD-87BA-FEC634D7A7BD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8E4A18-2E80-414B-86EA-964F84EA4E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FDAD69-6D9E-4F7A-ABE8-D102FB845E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3F2C64-AFFD-47F3-9A64-081AA25FF98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9F6739-622F-4B60-9F9F-ECB0180CBB8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A25DEAD-6978-4B37-8199-084F3841ECB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017530C-41DF-474F-84E4-20D7933F5F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BB7C5AD-ED1A-407F-B9C8-38394B53CC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CF951E5-9EE5-4F88-B348-2376251EAF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6A291C0-33D8-465C-ABA4-FFB173AA3F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31049E4-3E8F-40F0-A398-DEF1DB8C49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D38F606-B2DF-4A4E-B571-FF477496FF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73ABF8-8E7B-4DDA-82F9-F29D6EEB36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98E0004-C5CA-4E42-B0D5-098A5E076C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D81CCD0-CE0D-41A1-9AEC-19AD37701B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89208A8-FA6F-448C-AB5F-0832E1303A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C26B8F7-B683-4DEA-A5C9-2F4217994CB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7302C3B-11D6-4124-8A12-4BFD6653ABD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FAEB05E-D03A-4072-8D20-845C4FA736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26F3E46-F847-438C-96AF-85AB0A572D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C440BAC-B70B-4932-9B7D-B8256BCB90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D481F6D-3D56-4822-8FAE-D500C1C2BA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DEDEDBF-F14E-41C3-86C6-1E487FBE8B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64CD36-A7B2-492B-AC0D-4BC9A600E3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021300F-8AE9-4AEC-AE60-140094320E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9DB7D8C-6FF6-48E2-AD87-F61D849B2D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3F7128A-2C75-40F3-9B9D-0B4DA03EB7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967D3BA-08D7-4362-932A-D407E03473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1DB22A9-6950-4807-807B-AF8BDC4B55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3E73988-FB7A-43C7-971F-50C3BAEBE5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6997A89-A19D-4AEA-BFC3-8F59AC7DF62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5F03184-2BE3-460E-909E-170C5139210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DC5B514-49E7-4DAA-B6FC-7349555893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EAB1242-0A56-469A-A577-8D883896A5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42C876-FACF-4B37-8991-EFEB7A9788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6AE1FB5-03AF-46BE-945A-D3B0CA01AA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1DBF969-5DDA-40E6-A6F1-20AB0E8D03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8064127-F71B-40D6-84DB-1261772B8A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99E86E6-0503-4008-8FB5-79CBAA792F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C9B0EDF-8B04-4E4E-9DCE-8C6BCB4640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AD6DF4E-0DEE-4239-B22C-D6B7B8AD18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DE1F9DA-24E3-47E9-82A5-877C758573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283C6D0-B8E0-4608-9671-5B16091CF70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7EAB72C-76AD-4001-8469-51F51D87A0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2849DC-557B-4699-AB9A-6A3639F4AD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58F3CF-048B-402D-97BE-9B84B27CE4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4B04B4-15AB-4517-99EA-F3F9AEDA90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99EDBA-3969-426B-8301-D12E556740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59338F-2EE6-4E0D-A979-E76FD0CE43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4981460-DBC5-4372-8C6D-E838FD2BB3AC}" type="slidenum">
              <a:rPr b="0" lang="ja-JP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4435166-3FAC-448E-9DA0-9997D57B8A98}" type="slidenum">
              <a:rPr b="0" lang="ja-JP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29A47A9-2642-4962-8E44-43909F48E819}" type="slidenum">
              <a:rPr b="0" lang="ja-JP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D5B8CBD-0B37-44CA-837D-45075CE4693A}" type="slidenum">
              <a:rPr b="0" lang="ja-JP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image" Target="../media/image19.png"/><Relationship Id="rId4" Type="http://schemas.openxmlformats.org/officeDocument/2006/relationships/image" Target="../media/image20.png"/><Relationship Id="rId5" Type="http://schemas.openxmlformats.org/officeDocument/2006/relationships/image" Target="../media/image21.png"/><Relationship Id="rId6" Type="http://schemas.openxmlformats.org/officeDocument/2006/relationships/image" Target="../media/image22.png"/><Relationship Id="rId7" Type="http://schemas.openxmlformats.org/officeDocument/2006/relationships/image" Target="../media/image23.png"/><Relationship Id="rId8" Type="http://schemas.openxmlformats.org/officeDocument/2006/relationships/image" Target="../media/image24.png"/><Relationship Id="rId9" Type="http://schemas.openxmlformats.org/officeDocument/2006/relationships/image" Target="../media/image25.png"/><Relationship Id="rId10" Type="http://schemas.openxmlformats.org/officeDocument/2006/relationships/image" Target="../media/image26.png"/><Relationship Id="rId11" Type="http://schemas.openxmlformats.org/officeDocument/2006/relationships/image" Target="../media/image27.png"/><Relationship Id="rId12" Type="http://schemas.openxmlformats.org/officeDocument/2006/relationships/image" Target="../media/image28.png"/><Relationship Id="rId13" Type="http://schemas.openxmlformats.org/officeDocument/2006/relationships/slideLayout" Target="../slideLayouts/slideLayout37.xml"/><Relationship Id="rId14" Type="http://schemas.openxmlformats.org/officeDocument/2006/relationships/notesSlide" Target="../notesSlides/notesSlide10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25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3.xml"/><Relationship Id="rId4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3.xml"/><Relationship Id="rId4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slideLayout" Target="../slideLayouts/slideLayout13.xml"/><Relationship Id="rId4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slideLayout" Target="../slideLayouts/slideLayout13.xml"/><Relationship Id="rId4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slideLayout" Target="../slideLayouts/slideLayout13.xml"/><Relationship Id="rId4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image" Target="../media/image16.png"/><Relationship Id="rId3" Type="http://schemas.openxmlformats.org/officeDocument/2006/relationships/slideLayout" Target="../slideLayouts/slideLayout13.xml"/><Relationship Id="rId4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Rectangle 48"/>
          <p:cNvSpPr/>
          <p:nvPr/>
        </p:nvSpPr>
        <p:spPr>
          <a:xfrm>
            <a:off x="374400" y="139680"/>
            <a:ext cx="71056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Suppl Table1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-terminal sequences of sarkosyl-insoluble tau fragments identified by in gel digestion and LC/MS/MS analysi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72" name=""/>
          <p:cNvGraphicFramePr/>
          <p:nvPr/>
        </p:nvGraphicFramePr>
        <p:xfrm>
          <a:off x="419040" y="749160"/>
          <a:ext cx="8496360" cy="5564160"/>
        </p:xfrm>
        <a:graphic>
          <a:graphicData uri="http://schemas.openxmlformats.org/drawingml/2006/table">
            <a:tbl>
              <a:tblPr/>
              <a:tblGrid>
                <a:gridCol w="615960"/>
                <a:gridCol w="1001880"/>
                <a:gridCol w="693720"/>
                <a:gridCol w="957240"/>
                <a:gridCol w="682560"/>
                <a:gridCol w="1012680"/>
                <a:gridCol w="649440"/>
                <a:gridCol w="1089000"/>
                <a:gridCol w="682560"/>
                <a:gridCol w="1111320"/>
              </a:tblGrid>
              <a:tr h="221400">
                <a:tc grid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i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SP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B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i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3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3 AEEAGI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3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3 AEEAGI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6 DEAAGH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1 IATPRG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3 TPRGAA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16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3 AEEAGI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-40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7 MVSKSK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-40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7 MVSKSK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3 AEEAGI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8 AAGHVT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2 ATPRGA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6 GAAPPG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6 GAAPPG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2 ATPRGA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16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8 SSPGSP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2 KDGTGS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9 AKSRLQ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8 APKTPP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8 VVRTPP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2 ATPRGA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2 QKGQAN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2 KDGTGS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2 ATPRGA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16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8 SSPGSP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0 RIPAKT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9 VRTPPK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8 VVRTPP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5 TGSDDK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6 VAVVRT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8 VVRTPP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16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1 SRLQTA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9 SPGSPG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7 EPPKSG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4 RSGYSS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6 VAVVRT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5 TAPVPM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9 AKSRLQ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2 PPKSPS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8 VVRTPP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5 TAPVPM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5 TAPVPM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9 VRTPPK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5 TAPVPM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16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7 PVPMPD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7 IKHVPG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kD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8 SSPGSP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9 AKSRLQ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16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5 TAPVPM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4 GSVQIV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5 SVQIVY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6 VQIVYK--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92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　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テキスト ボックス 26"/>
          <p:cNvSpPr/>
          <p:nvPr/>
        </p:nvSpPr>
        <p:spPr>
          <a:xfrm>
            <a:off x="9753480" y="1973160"/>
            <a:ext cx="184320" cy="37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テキスト ボックス 196"/>
          <p:cNvSpPr/>
          <p:nvPr/>
        </p:nvSpPr>
        <p:spPr>
          <a:xfrm>
            <a:off x="861840" y="1052640"/>
            <a:ext cx="598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メイリオ"/>
                <a:ea typeface="メイリオ"/>
              </a:rPr>
              <a:t>AD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4" name="テキスト ボックス 337"/>
          <p:cNvSpPr/>
          <p:nvPr/>
        </p:nvSpPr>
        <p:spPr>
          <a:xfrm>
            <a:off x="4336920" y="1052640"/>
            <a:ext cx="745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メイリオ"/>
                <a:ea typeface="メイリオ"/>
              </a:rPr>
              <a:t> </a:t>
            </a:r>
            <a:r>
              <a:rPr b="0" lang="en-US" sz="2400" spc="-1" strike="noStrike">
                <a:solidFill>
                  <a:srgbClr val="000000"/>
                </a:solidFill>
                <a:latin typeface="メイリオ"/>
                <a:ea typeface="メイリオ"/>
              </a:rPr>
              <a:t>PiD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テキスト ボックス 338"/>
          <p:cNvSpPr/>
          <p:nvPr/>
        </p:nvSpPr>
        <p:spPr>
          <a:xfrm>
            <a:off x="804240" y="3495600"/>
            <a:ext cx="717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メイリオ"/>
                <a:ea typeface="メイリオ"/>
              </a:rPr>
              <a:t>PSP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6" name="図形グループ 12"/>
          <p:cNvGrpSpPr/>
          <p:nvPr/>
        </p:nvGrpSpPr>
        <p:grpSpPr>
          <a:xfrm>
            <a:off x="1779480" y="3583080"/>
            <a:ext cx="2435400" cy="1850760"/>
            <a:chOff x="1779480" y="3583080"/>
            <a:chExt cx="2435400" cy="1850760"/>
          </a:xfrm>
        </p:grpSpPr>
        <p:pic>
          <p:nvPicPr>
            <p:cNvPr id="427" name="図形グループ 7" descr=""/>
            <p:cNvPicPr/>
            <p:nvPr/>
          </p:nvPicPr>
          <p:blipFill>
            <a:blip r:embed="rId1"/>
            <a:stretch/>
          </p:blipFill>
          <p:spPr>
            <a:xfrm>
              <a:off x="1796760" y="4199760"/>
              <a:ext cx="2400840" cy="664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28" name="図形グループ 225" descr=""/>
            <p:cNvPicPr/>
            <p:nvPr/>
          </p:nvPicPr>
          <p:blipFill>
            <a:blip r:embed="rId2"/>
            <a:stretch/>
          </p:blipFill>
          <p:spPr>
            <a:xfrm>
              <a:off x="1779480" y="4788000"/>
              <a:ext cx="2429640" cy="645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29" name="図形グループ 6" descr=""/>
            <p:cNvPicPr/>
            <p:nvPr/>
          </p:nvPicPr>
          <p:blipFill>
            <a:blip r:embed="rId3"/>
            <a:stretch/>
          </p:blipFill>
          <p:spPr>
            <a:xfrm>
              <a:off x="1779480" y="3583080"/>
              <a:ext cx="2435400" cy="684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30" name="テキスト ボックス 339"/>
          <p:cNvSpPr/>
          <p:nvPr/>
        </p:nvSpPr>
        <p:spPr>
          <a:xfrm>
            <a:off x="1133280" y="468324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メイリオ"/>
                <a:ea typeface="メイリオ"/>
              </a:rPr>
              <a:t>10kD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テキスト ボックス 340"/>
          <p:cNvSpPr/>
          <p:nvPr/>
        </p:nvSpPr>
        <p:spPr>
          <a:xfrm>
            <a:off x="1133280" y="432288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メイリオ"/>
                <a:ea typeface="メイリオ"/>
              </a:rPr>
              <a:t>15kD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テキスト ボックス 341"/>
          <p:cNvSpPr/>
          <p:nvPr/>
        </p:nvSpPr>
        <p:spPr>
          <a:xfrm>
            <a:off x="1133280" y="3963960"/>
            <a:ext cx="70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メイリオ"/>
                <a:ea typeface="メイリオ"/>
              </a:rPr>
              <a:t>16kD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テキスト ボックス 342"/>
          <p:cNvSpPr/>
          <p:nvPr/>
        </p:nvSpPr>
        <p:spPr>
          <a:xfrm>
            <a:off x="4411080" y="3495600"/>
            <a:ext cx="7934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メイリオ"/>
                <a:ea typeface="メイリオ"/>
              </a:rPr>
              <a:t>CBD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4" name="図形グループ 11" descr=""/>
          <p:cNvPicPr/>
          <p:nvPr/>
        </p:nvPicPr>
        <p:blipFill>
          <a:blip r:embed="rId4"/>
          <a:stretch/>
        </p:blipFill>
        <p:spPr>
          <a:xfrm>
            <a:off x="5383080" y="4334040"/>
            <a:ext cx="2554560" cy="414000"/>
          </a:xfrm>
          <a:prstGeom prst="rect">
            <a:avLst/>
          </a:prstGeom>
          <a:ln w="0">
            <a:noFill/>
          </a:ln>
        </p:spPr>
      </p:pic>
      <p:pic>
        <p:nvPicPr>
          <p:cNvPr id="435" name="図形グループ 10" descr=""/>
          <p:cNvPicPr/>
          <p:nvPr/>
        </p:nvPicPr>
        <p:blipFill>
          <a:blip r:embed="rId5"/>
          <a:stretch/>
        </p:blipFill>
        <p:spPr>
          <a:xfrm>
            <a:off x="5370480" y="3962520"/>
            <a:ext cx="2597040" cy="426960"/>
          </a:xfrm>
          <a:prstGeom prst="rect">
            <a:avLst/>
          </a:prstGeom>
          <a:ln w="0">
            <a:noFill/>
          </a:ln>
        </p:spPr>
      </p:pic>
      <p:pic>
        <p:nvPicPr>
          <p:cNvPr id="436" name="図形グループ 8" descr=""/>
          <p:cNvPicPr/>
          <p:nvPr/>
        </p:nvPicPr>
        <p:blipFill>
          <a:blip r:embed="rId6"/>
          <a:stretch/>
        </p:blipFill>
        <p:spPr>
          <a:xfrm>
            <a:off x="5327640" y="4668840"/>
            <a:ext cx="2664000" cy="457200"/>
          </a:xfrm>
          <a:prstGeom prst="rect">
            <a:avLst/>
          </a:prstGeom>
          <a:ln w="0">
            <a:noFill/>
          </a:ln>
        </p:spPr>
      </p:pic>
      <p:sp>
        <p:nvSpPr>
          <p:cNvPr id="437" name="テキスト ボックス 343"/>
          <p:cNvSpPr/>
          <p:nvPr/>
        </p:nvSpPr>
        <p:spPr>
          <a:xfrm>
            <a:off x="4560120" y="4843440"/>
            <a:ext cx="981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メイリオ"/>
                <a:ea typeface="メイリオ"/>
              </a:rPr>
              <a:t>10/10kD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テキスト ボックス 345"/>
          <p:cNvSpPr/>
          <p:nvPr/>
        </p:nvSpPr>
        <p:spPr>
          <a:xfrm>
            <a:off x="4560120" y="4113360"/>
            <a:ext cx="981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メイリオ"/>
                <a:ea typeface="メイリオ"/>
              </a:rPr>
              <a:t>15/15kD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9" name="テキスト ボックス 345"/>
          <p:cNvSpPr/>
          <p:nvPr/>
        </p:nvSpPr>
        <p:spPr>
          <a:xfrm>
            <a:off x="4560120" y="4484520"/>
            <a:ext cx="981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メイリオ"/>
                <a:ea typeface="メイリオ"/>
              </a:rPr>
              <a:t>13/13kD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上矢印 1"/>
          <p:cNvSpPr/>
          <p:nvPr/>
        </p:nvSpPr>
        <p:spPr>
          <a:xfrm>
            <a:off x="8053560" y="1569960"/>
            <a:ext cx="331560" cy="1224000"/>
          </a:xfrm>
          <a:prstGeom prst="upArrow">
            <a:avLst>
              <a:gd name="adj1" fmla="val 50000"/>
              <a:gd name="adj2" fmla="val 105468"/>
            </a:avLst>
          </a:prstGeom>
          <a:noFill/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テキスト ボックス 2"/>
          <p:cNvSpPr/>
          <p:nvPr/>
        </p:nvSpPr>
        <p:spPr>
          <a:xfrm>
            <a:off x="7898040" y="2967120"/>
            <a:ext cx="6501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1f497d"/>
                </a:solidFill>
                <a:latin typeface="メイリオ"/>
                <a:ea typeface="メイリオ"/>
              </a:rPr>
              <a:t>Fibri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1f497d"/>
                </a:solidFill>
                <a:latin typeface="メイリオ"/>
                <a:ea typeface="メイリオ"/>
              </a:rPr>
              <a:t>axi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42" name="図形グループ 16"/>
          <p:cNvGrpSpPr/>
          <p:nvPr/>
        </p:nvGrpSpPr>
        <p:grpSpPr>
          <a:xfrm>
            <a:off x="6516720" y="5345280"/>
            <a:ext cx="554040" cy="407880"/>
            <a:chOff x="6516720" y="5345280"/>
            <a:chExt cx="554040" cy="407880"/>
          </a:xfrm>
        </p:grpSpPr>
        <p:sp>
          <p:nvSpPr>
            <p:cNvPr id="443" name="AutoShape 159"/>
            <p:cNvSpPr/>
            <p:nvPr/>
          </p:nvSpPr>
          <p:spPr>
            <a:xfrm>
              <a:off x="6516720" y="5357880"/>
              <a:ext cx="363600" cy="395280"/>
            </a:xfrm>
            <a:prstGeom prst="diamond">
              <a:avLst/>
            </a:prstGeom>
            <a:gradFill rotWithShape="0">
              <a:gsLst>
                <a:gs pos="0">
                  <a:srgbClr val="ffffff"/>
                </a:gs>
                <a:gs pos="100000">
                  <a:srgbClr val="ff0000"/>
                </a:gs>
              </a:gsLst>
              <a:path path="rect">
                <a:fillToRect l="50000" t="50000" r="50000" b="50000"/>
              </a:path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4" name="AutoShape 159"/>
            <p:cNvSpPr/>
            <p:nvPr/>
          </p:nvSpPr>
          <p:spPr>
            <a:xfrm>
              <a:off x="6707160" y="5345280"/>
              <a:ext cx="363600" cy="395280"/>
            </a:xfrm>
            <a:prstGeom prst="diamond">
              <a:avLst/>
            </a:prstGeom>
            <a:gradFill rotWithShape="0">
              <a:gsLst>
                <a:gs pos="0">
                  <a:srgbClr val="ffffff"/>
                </a:gs>
                <a:gs pos="100000">
                  <a:srgbClr val="ff0000"/>
                </a:gs>
              </a:gsLst>
              <a:path path="rect">
                <a:fillToRect l="50000" t="50000" r="50000" b="50000"/>
              </a:path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45" name="図形グループ 14"/>
          <p:cNvGrpSpPr/>
          <p:nvPr/>
        </p:nvGrpSpPr>
        <p:grpSpPr>
          <a:xfrm>
            <a:off x="4768920" y="1197000"/>
            <a:ext cx="3124080" cy="2006640"/>
            <a:chOff x="4768920" y="1197000"/>
            <a:chExt cx="3124080" cy="2006640"/>
          </a:xfrm>
        </p:grpSpPr>
        <p:pic>
          <p:nvPicPr>
            <p:cNvPr id="446" name="図形グループ 20" descr=""/>
            <p:cNvPicPr/>
            <p:nvPr/>
          </p:nvPicPr>
          <p:blipFill>
            <a:blip r:embed="rId7"/>
            <a:stretch/>
          </p:blipFill>
          <p:spPr>
            <a:xfrm>
              <a:off x="5393160" y="1585800"/>
              <a:ext cx="2469960" cy="498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7" name="図形グループ 19" descr=""/>
            <p:cNvPicPr/>
            <p:nvPr/>
          </p:nvPicPr>
          <p:blipFill>
            <a:blip r:embed="rId8"/>
            <a:stretch/>
          </p:blipFill>
          <p:spPr>
            <a:xfrm>
              <a:off x="5363280" y="1989360"/>
              <a:ext cx="2529720" cy="484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8" name="テキスト ボックス 335"/>
            <p:cNvSpPr/>
            <p:nvPr/>
          </p:nvSpPr>
          <p:spPr>
            <a:xfrm>
              <a:off x="4768920" y="1697760"/>
              <a:ext cx="709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メイリオ"/>
                  <a:ea typeface="メイリオ"/>
                </a:rPr>
                <a:t>12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9" name="テキスト ボックス 335"/>
            <p:cNvSpPr/>
            <p:nvPr/>
          </p:nvSpPr>
          <p:spPr>
            <a:xfrm>
              <a:off x="4777200" y="2144520"/>
              <a:ext cx="709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メイリオ"/>
                  <a:ea typeface="メイリオ"/>
                </a:rPr>
                <a:t>12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50" name="図形グループ 20" descr=""/>
            <p:cNvPicPr/>
            <p:nvPr/>
          </p:nvPicPr>
          <p:blipFill>
            <a:blip r:embed="rId9"/>
            <a:stretch/>
          </p:blipFill>
          <p:spPr>
            <a:xfrm>
              <a:off x="5387040" y="1197000"/>
              <a:ext cx="2469960" cy="498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1" name="テキスト ボックス 335"/>
            <p:cNvSpPr/>
            <p:nvPr/>
          </p:nvSpPr>
          <p:spPr>
            <a:xfrm>
              <a:off x="4769640" y="1264320"/>
              <a:ext cx="709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メイリオ"/>
                  <a:ea typeface="メイリオ"/>
                </a:rPr>
                <a:t>12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2" name="AutoShape 137"/>
            <p:cNvSpPr/>
            <p:nvPr/>
          </p:nvSpPr>
          <p:spPr>
            <a:xfrm rot="16200000">
              <a:off x="6438240" y="2722320"/>
              <a:ext cx="474840" cy="354600"/>
            </a:xfrm>
            <a:prstGeom prst="triangle">
              <a:avLst>
                <a:gd name="adj" fmla="val 50000"/>
              </a:avLst>
            </a:prstGeom>
            <a:gradFill rotWithShape="0">
              <a:gsLst>
                <a:gs pos="0">
                  <a:srgbClr val="ffffff"/>
                </a:gs>
                <a:gs pos="100000">
                  <a:srgbClr val="0000ff"/>
                </a:gs>
              </a:gsLst>
              <a:path path="rect">
                <a:fillToRect l="50000" t="50000" r="50000" b="50000"/>
              </a:path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 vert="eaVert" rot="10800000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3" name="AutoShape 137"/>
            <p:cNvSpPr/>
            <p:nvPr/>
          </p:nvSpPr>
          <p:spPr>
            <a:xfrm rot="5400000">
              <a:off x="6375960" y="2788920"/>
              <a:ext cx="474840" cy="354600"/>
            </a:xfrm>
            <a:prstGeom prst="triangle">
              <a:avLst>
                <a:gd name="adj" fmla="val 50000"/>
              </a:avLst>
            </a:prstGeom>
            <a:gradFill rotWithShape="0">
              <a:gsLst>
                <a:gs pos="0">
                  <a:srgbClr val="ffffff"/>
                </a:gs>
                <a:gs pos="100000">
                  <a:srgbClr val="0000ff"/>
                </a:gs>
              </a:gsLst>
              <a:path path="rect">
                <a:fillToRect l="50000" t="50000" r="50000" b="50000"/>
              </a:path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 vert="eaVert" rot="10800000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54" name="図形グループ 4"/>
          <p:cNvGrpSpPr/>
          <p:nvPr/>
        </p:nvGrpSpPr>
        <p:grpSpPr>
          <a:xfrm>
            <a:off x="1133640" y="1239840"/>
            <a:ext cx="3081240" cy="2001960"/>
            <a:chOff x="1133640" y="1239840"/>
            <a:chExt cx="3081240" cy="2001960"/>
          </a:xfrm>
        </p:grpSpPr>
        <p:sp>
          <p:nvSpPr>
            <p:cNvPr id="455" name="テキスト ボックス 199"/>
            <p:cNvSpPr/>
            <p:nvPr/>
          </p:nvSpPr>
          <p:spPr>
            <a:xfrm>
              <a:off x="1207800" y="2259360"/>
              <a:ext cx="607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メイリオ"/>
                  <a:ea typeface="メイリオ"/>
                </a:rPr>
                <a:t>7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6" name="テキスト ボックス 208"/>
            <p:cNvSpPr/>
            <p:nvPr/>
          </p:nvSpPr>
          <p:spPr>
            <a:xfrm>
              <a:off x="1133640" y="1960200"/>
              <a:ext cx="709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メイリオ"/>
                  <a:ea typeface="メイリオ"/>
                </a:rPr>
                <a:t>12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7" name="テキスト ボックス 242"/>
            <p:cNvSpPr/>
            <p:nvPr/>
          </p:nvSpPr>
          <p:spPr>
            <a:xfrm>
              <a:off x="1133640" y="1671840"/>
              <a:ext cx="709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メイリオ"/>
                  <a:ea typeface="メイリオ"/>
                </a:rPr>
                <a:t>15kD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58" name="図形グループ 13"/>
            <p:cNvGrpSpPr/>
            <p:nvPr/>
          </p:nvGrpSpPr>
          <p:grpSpPr>
            <a:xfrm>
              <a:off x="1780560" y="1239840"/>
              <a:ext cx="2434320" cy="1662840"/>
              <a:chOff x="1780560" y="1239840"/>
              <a:chExt cx="2434320" cy="1662840"/>
            </a:xfrm>
          </p:grpSpPr>
          <p:pic>
            <p:nvPicPr>
              <p:cNvPr id="459" name="図形グループ 16" descr=""/>
              <p:cNvPicPr/>
              <p:nvPr/>
            </p:nvPicPr>
            <p:blipFill>
              <a:blip r:embed="rId10"/>
              <a:stretch/>
            </p:blipFill>
            <p:spPr>
              <a:xfrm>
                <a:off x="1803600" y="1746720"/>
                <a:ext cx="2405520" cy="689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0" name="図形グループ 17" descr=""/>
              <p:cNvPicPr/>
              <p:nvPr/>
            </p:nvPicPr>
            <p:blipFill>
              <a:blip r:embed="rId11"/>
              <a:stretch/>
            </p:blipFill>
            <p:spPr>
              <a:xfrm>
                <a:off x="1780560" y="2213280"/>
                <a:ext cx="2434320" cy="689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1" name="図形グループ 259" descr=""/>
              <p:cNvPicPr/>
              <p:nvPr/>
            </p:nvPicPr>
            <p:blipFill>
              <a:blip r:embed="rId12"/>
              <a:stretch/>
            </p:blipFill>
            <p:spPr>
              <a:xfrm>
                <a:off x="1797840" y="1239840"/>
                <a:ext cx="2405520" cy="70956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462" name="AutoShape 159"/>
            <p:cNvSpPr/>
            <p:nvPr/>
          </p:nvSpPr>
          <p:spPr>
            <a:xfrm>
              <a:off x="2737800" y="2830680"/>
              <a:ext cx="363600" cy="396000"/>
            </a:xfrm>
            <a:prstGeom prst="diamond">
              <a:avLst/>
            </a:prstGeom>
            <a:gradFill rotWithShape="0">
              <a:gsLst>
                <a:gs pos="0">
                  <a:srgbClr val="ffffff"/>
                </a:gs>
                <a:gs pos="100000">
                  <a:srgbClr val="ff0000"/>
                </a:gs>
              </a:gsLst>
              <a:path path="rect">
                <a:fillToRect l="50000" t="50000" r="50000" b="50000"/>
              </a:path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3" name="AutoShape 137"/>
            <p:cNvSpPr/>
            <p:nvPr/>
          </p:nvSpPr>
          <p:spPr>
            <a:xfrm rot="16200000">
              <a:off x="2860560" y="2863440"/>
              <a:ext cx="394560" cy="362160"/>
            </a:xfrm>
            <a:prstGeom prst="triangle">
              <a:avLst>
                <a:gd name="adj" fmla="val 50000"/>
              </a:avLst>
            </a:prstGeom>
            <a:gradFill rotWithShape="0">
              <a:gsLst>
                <a:gs pos="0">
                  <a:srgbClr val="ffffff"/>
                </a:gs>
                <a:gs pos="100000">
                  <a:srgbClr val="0000ff"/>
                </a:gs>
              </a:gsLst>
              <a:path path="rect">
                <a:fillToRect l="50000" t="50000" r="50000" b="50000"/>
              </a:path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 vert="eaVert" rot="10800000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64" name="図形グループ 15"/>
          <p:cNvGrpSpPr/>
          <p:nvPr/>
        </p:nvGrpSpPr>
        <p:grpSpPr>
          <a:xfrm>
            <a:off x="2672640" y="5317200"/>
            <a:ext cx="713880" cy="545040"/>
            <a:chOff x="2672640" y="5317200"/>
            <a:chExt cx="713880" cy="545040"/>
          </a:xfrm>
        </p:grpSpPr>
        <p:sp>
          <p:nvSpPr>
            <p:cNvPr id="465" name="AutoShape 159"/>
            <p:cNvSpPr/>
            <p:nvPr/>
          </p:nvSpPr>
          <p:spPr>
            <a:xfrm rot="2046600">
              <a:off x="2752560" y="5397480"/>
              <a:ext cx="363600" cy="396720"/>
            </a:xfrm>
            <a:prstGeom prst="diamond">
              <a:avLst/>
            </a:prstGeom>
            <a:gradFill rotWithShape="0">
              <a:gsLst>
                <a:gs pos="0">
                  <a:srgbClr val="ffffff"/>
                </a:gs>
                <a:gs pos="100000">
                  <a:srgbClr val="ff0000"/>
                </a:gs>
              </a:gsLst>
              <a:path path="rect">
                <a:fillToRect l="50000" t="50000" r="50000" b="50000"/>
              </a:path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6" name="AutoShape 159"/>
            <p:cNvSpPr/>
            <p:nvPr/>
          </p:nvSpPr>
          <p:spPr>
            <a:xfrm rot="2046600">
              <a:off x="2943000" y="5384880"/>
              <a:ext cx="363600" cy="396720"/>
            </a:xfrm>
            <a:prstGeom prst="diamond">
              <a:avLst/>
            </a:prstGeom>
            <a:gradFill rotWithShape="0">
              <a:gsLst>
                <a:gs pos="0">
                  <a:srgbClr val="ffffff"/>
                </a:gs>
                <a:gs pos="100000">
                  <a:srgbClr val="ff0000"/>
                </a:gs>
              </a:gsLst>
              <a:path path="rect">
                <a:fillToRect l="50000" t="50000" r="50000" b="50000"/>
              </a:path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67" name="Rectangle 48"/>
          <p:cNvSpPr/>
          <p:nvPr/>
        </p:nvSpPr>
        <p:spPr>
          <a:xfrm>
            <a:off x="253800" y="84240"/>
            <a:ext cx="1467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MS PGothic"/>
              </a:rPr>
              <a:t>Suppl Fig 9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3" name="図 4" descr=""/>
          <p:cNvPicPr/>
          <p:nvPr/>
        </p:nvPicPr>
        <p:blipFill>
          <a:blip r:embed="rId1"/>
          <a:stretch/>
        </p:blipFill>
        <p:spPr>
          <a:xfrm>
            <a:off x="2349360" y="3594240"/>
            <a:ext cx="5124600" cy="3187440"/>
          </a:xfrm>
          <a:prstGeom prst="rect">
            <a:avLst/>
          </a:prstGeom>
          <a:ln w="0">
            <a:noFill/>
          </a:ln>
        </p:spPr>
      </p:pic>
      <p:sp>
        <p:nvSpPr>
          <p:cNvPr id="174" name="Rectangle 48"/>
          <p:cNvSpPr/>
          <p:nvPr/>
        </p:nvSpPr>
        <p:spPr>
          <a:xfrm>
            <a:off x="116280" y="76320"/>
            <a:ext cx="146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Suppl Fig 1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Rectangle 48"/>
          <p:cNvSpPr/>
          <p:nvPr/>
        </p:nvSpPr>
        <p:spPr>
          <a:xfrm>
            <a:off x="268200" y="3809880"/>
            <a:ext cx="146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Suppl Fig 1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6" name="図 1" descr=""/>
          <p:cNvPicPr/>
          <p:nvPr/>
        </p:nvPicPr>
        <p:blipFill>
          <a:blip r:embed="rId2"/>
          <a:stretch/>
        </p:blipFill>
        <p:spPr>
          <a:xfrm>
            <a:off x="1143000" y="566640"/>
            <a:ext cx="7097760" cy="2906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Rectangle 48"/>
          <p:cNvSpPr/>
          <p:nvPr/>
        </p:nvSpPr>
        <p:spPr>
          <a:xfrm>
            <a:off x="1291680" y="143496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Rectangle 49"/>
          <p:cNvSpPr/>
          <p:nvPr/>
        </p:nvSpPr>
        <p:spPr>
          <a:xfrm>
            <a:off x="4798440" y="14382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79" name="図形グループ 1"/>
          <p:cNvGrpSpPr/>
          <p:nvPr/>
        </p:nvGrpSpPr>
        <p:grpSpPr>
          <a:xfrm>
            <a:off x="1456200" y="1839960"/>
            <a:ext cx="6435000" cy="3409200"/>
            <a:chOff x="1456200" y="1839960"/>
            <a:chExt cx="6435000" cy="3409200"/>
          </a:xfrm>
        </p:grpSpPr>
        <p:sp>
          <p:nvSpPr>
            <p:cNvPr id="180" name="AutoShape 5"/>
            <p:cNvSpPr/>
            <p:nvPr/>
          </p:nvSpPr>
          <p:spPr>
            <a:xfrm flipH="1">
              <a:off x="5812920" y="2316240"/>
              <a:ext cx="1461960" cy="99720"/>
            </a:xfrm>
            <a:prstGeom prst="rtTriangl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4400" bIns="-144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Line 6"/>
            <p:cNvSpPr/>
            <p:nvPr/>
          </p:nvSpPr>
          <p:spPr>
            <a:xfrm>
              <a:off x="5562720" y="4268880"/>
              <a:ext cx="1317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Line 7"/>
            <p:cNvSpPr/>
            <p:nvPr/>
          </p:nvSpPr>
          <p:spPr>
            <a:xfrm>
              <a:off x="5562720" y="3987720"/>
              <a:ext cx="1317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Line 8"/>
            <p:cNvSpPr/>
            <p:nvPr/>
          </p:nvSpPr>
          <p:spPr>
            <a:xfrm>
              <a:off x="5556240" y="3697200"/>
              <a:ext cx="1332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Rectangle 9"/>
            <p:cNvSpPr/>
            <p:nvPr/>
          </p:nvSpPr>
          <p:spPr>
            <a:xfrm>
              <a:off x="5180040" y="4071960"/>
              <a:ext cx="598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Rectangle 10"/>
            <p:cNvSpPr/>
            <p:nvPr/>
          </p:nvSpPr>
          <p:spPr>
            <a:xfrm>
              <a:off x="5182560" y="3801960"/>
              <a:ext cx="37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Rectangle 11"/>
            <p:cNvSpPr/>
            <p:nvPr/>
          </p:nvSpPr>
          <p:spPr>
            <a:xfrm>
              <a:off x="5182560" y="3276720"/>
              <a:ext cx="37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2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Line 12"/>
            <p:cNvSpPr/>
            <p:nvPr/>
          </p:nvSpPr>
          <p:spPr>
            <a:xfrm>
              <a:off x="5562720" y="3444840"/>
              <a:ext cx="1317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Line 13"/>
            <p:cNvSpPr/>
            <p:nvPr/>
          </p:nvSpPr>
          <p:spPr>
            <a:xfrm>
              <a:off x="5546880" y="2940120"/>
              <a:ext cx="1332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Line 14"/>
            <p:cNvSpPr/>
            <p:nvPr/>
          </p:nvSpPr>
          <p:spPr>
            <a:xfrm>
              <a:off x="5556240" y="2639880"/>
              <a:ext cx="1332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Rectangle 15"/>
            <p:cNvSpPr/>
            <p:nvPr/>
          </p:nvSpPr>
          <p:spPr>
            <a:xfrm>
              <a:off x="5187600" y="3498840"/>
              <a:ext cx="37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2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Rectangle 16"/>
            <p:cNvSpPr/>
            <p:nvPr/>
          </p:nvSpPr>
          <p:spPr>
            <a:xfrm>
              <a:off x="5182560" y="3071880"/>
              <a:ext cx="37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37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Rectangle 17"/>
            <p:cNvSpPr/>
            <p:nvPr/>
          </p:nvSpPr>
          <p:spPr>
            <a:xfrm>
              <a:off x="5181120" y="2744640"/>
              <a:ext cx="37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5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Rectangle 18"/>
            <p:cNvSpPr/>
            <p:nvPr/>
          </p:nvSpPr>
          <p:spPr>
            <a:xfrm>
              <a:off x="5120280" y="2190600"/>
              <a:ext cx="6166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(kDa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7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Line 19"/>
            <p:cNvSpPr/>
            <p:nvPr/>
          </p:nvSpPr>
          <p:spPr>
            <a:xfrm>
              <a:off x="5542200" y="3243240"/>
              <a:ext cx="1332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AutoShape 22"/>
            <p:cNvSpPr/>
            <p:nvPr/>
          </p:nvSpPr>
          <p:spPr>
            <a:xfrm flipH="1">
              <a:off x="2520360" y="2241360"/>
              <a:ext cx="1339560" cy="93600"/>
            </a:xfrm>
            <a:prstGeom prst="rtTriangl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6200" bIns="-16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Line 23"/>
            <p:cNvSpPr/>
            <p:nvPr/>
          </p:nvSpPr>
          <p:spPr>
            <a:xfrm>
              <a:off x="2239920" y="4364280"/>
              <a:ext cx="1332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Line 24"/>
            <p:cNvSpPr/>
            <p:nvPr/>
          </p:nvSpPr>
          <p:spPr>
            <a:xfrm>
              <a:off x="2239920" y="3946680"/>
              <a:ext cx="1332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Line 25"/>
            <p:cNvSpPr/>
            <p:nvPr/>
          </p:nvSpPr>
          <p:spPr>
            <a:xfrm>
              <a:off x="2219400" y="3371760"/>
              <a:ext cx="1332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Rectangle 26"/>
            <p:cNvSpPr/>
            <p:nvPr/>
          </p:nvSpPr>
          <p:spPr>
            <a:xfrm>
              <a:off x="1851120" y="4184640"/>
              <a:ext cx="598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37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Rectangle 27"/>
            <p:cNvSpPr/>
            <p:nvPr/>
          </p:nvSpPr>
          <p:spPr>
            <a:xfrm>
              <a:off x="1853640" y="3733920"/>
              <a:ext cx="37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5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Line 30"/>
            <p:cNvSpPr/>
            <p:nvPr/>
          </p:nvSpPr>
          <p:spPr>
            <a:xfrm>
              <a:off x="2209680" y="2797200"/>
              <a:ext cx="1332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Line 31"/>
            <p:cNvSpPr/>
            <p:nvPr/>
          </p:nvSpPr>
          <p:spPr>
            <a:xfrm>
              <a:off x="2219400" y="2639880"/>
              <a:ext cx="1332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Rectangle 33"/>
            <p:cNvSpPr/>
            <p:nvPr/>
          </p:nvSpPr>
          <p:spPr>
            <a:xfrm>
              <a:off x="1843920" y="3181320"/>
              <a:ext cx="37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7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Rectangle 34"/>
            <p:cNvSpPr/>
            <p:nvPr/>
          </p:nvSpPr>
          <p:spPr>
            <a:xfrm>
              <a:off x="1766520" y="2940120"/>
              <a:ext cx="478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0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Rectangle 35"/>
            <p:cNvSpPr/>
            <p:nvPr/>
          </p:nvSpPr>
          <p:spPr>
            <a:xfrm>
              <a:off x="1710000" y="2158920"/>
              <a:ext cx="6166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(kDa)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25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Line 36"/>
            <p:cNvSpPr/>
            <p:nvPr/>
          </p:nvSpPr>
          <p:spPr>
            <a:xfrm>
              <a:off x="2219400" y="3147840"/>
              <a:ext cx="1317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Rectangle 37"/>
            <p:cNvSpPr/>
            <p:nvPr/>
          </p:nvSpPr>
          <p:spPr>
            <a:xfrm>
              <a:off x="1456200" y="1839960"/>
              <a:ext cx="3053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MS Gothic"/>
                </a:rPr>
                <a:t>Trypsin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 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     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0   0.5  1.0   2.0 mg/mL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Rectangle 39"/>
            <p:cNvSpPr/>
            <p:nvPr/>
          </p:nvSpPr>
          <p:spPr>
            <a:xfrm>
              <a:off x="3815640" y="4911840"/>
              <a:ext cx="529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T46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Rectangle 40"/>
            <p:cNvSpPr/>
            <p:nvPr/>
          </p:nvSpPr>
          <p:spPr>
            <a:xfrm>
              <a:off x="6903720" y="4884840"/>
              <a:ext cx="7887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TauC4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Rectangle 41"/>
            <p:cNvSpPr/>
            <p:nvPr/>
          </p:nvSpPr>
          <p:spPr>
            <a:xfrm>
              <a:off x="4837680" y="1895400"/>
              <a:ext cx="3053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MS Gothic"/>
                </a:rPr>
                <a:t>Trypsin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MS Gothic"/>
                </a:rPr>
                <a:t>     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Gothic"/>
                </a:rPr>
                <a:t>0   0.5   1.0   2.0 mg/mL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Line 44"/>
            <p:cNvSpPr/>
            <p:nvPr/>
          </p:nvSpPr>
          <p:spPr>
            <a:xfrm>
              <a:off x="7245720" y="4016520"/>
              <a:ext cx="264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head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Line 45"/>
            <p:cNvSpPr/>
            <p:nvPr/>
          </p:nvSpPr>
          <p:spPr>
            <a:xfrm>
              <a:off x="7245720" y="4175280"/>
              <a:ext cx="264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head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Line 46"/>
            <p:cNvSpPr/>
            <p:nvPr/>
          </p:nvSpPr>
          <p:spPr>
            <a:xfrm>
              <a:off x="7245720" y="4327560"/>
              <a:ext cx="264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head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Rectangle 59"/>
            <p:cNvSpPr/>
            <p:nvPr/>
          </p:nvSpPr>
          <p:spPr>
            <a:xfrm>
              <a:off x="7406280" y="383400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MS Gothic"/>
                </a:rPr>
                <a:t>1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Rectangle 60"/>
            <p:cNvSpPr/>
            <p:nvPr/>
          </p:nvSpPr>
          <p:spPr>
            <a:xfrm>
              <a:off x="7406280" y="401004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MS Gothic"/>
                </a:rPr>
                <a:t>1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Rectangle 61"/>
            <p:cNvSpPr/>
            <p:nvPr/>
          </p:nvSpPr>
          <p:spPr>
            <a:xfrm>
              <a:off x="7450560" y="416880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MS Gothic"/>
                </a:rPr>
                <a:t>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17" name="Picture 66" descr=""/>
            <p:cNvPicPr/>
            <p:nvPr/>
          </p:nvPicPr>
          <p:blipFill>
            <a:blip r:embed="rId1"/>
            <a:stretch/>
          </p:blipFill>
          <p:spPr>
            <a:xfrm>
              <a:off x="2400120" y="2414520"/>
              <a:ext cx="1474560" cy="2392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18" name="Rectangle 67"/>
            <p:cNvSpPr/>
            <p:nvPr/>
          </p:nvSpPr>
          <p:spPr>
            <a:xfrm>
              <a:off x="1752120" y="2620800"/>
              <a:ext cx="478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15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19" name="Picture 68" descr=""/>
            <p:cNvPicPr/>
            <p:nvPr/>
          </p:nvPicPr>
          <p:blipFill>
            <a:blip r:embed="rId2"/>
            <a:stretch/>
          </p:blipFill>
          <p:spPr>
            <a:xfrm>
              <a:off x="5769000" y="2493720"/>
              <a:ext cx="1474560" cy="22971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20" name="Rectangle 48"/>
          <p:cNvSpPr/>
          <p:nvPr/>
        </p:nvSpPr>
        <p:spPr>
          <a:xfrm>
            <a:off x="370800" y="139680"/>
            <a:ext cx="1720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Suppl Fig 2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Rectangle 38"/>
          <p:cNvSpPr/>
          <p:nvPr/>
        </p:nvSpPr>
        <p:spPr>
          <a:xfrm>
            <a:off x="844200" y="70344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Rectangle 10"/>
          <p:cNvSpPr/>
          <p:nvPr/>
        </p:nvSpPr>
        <p:spPr>
          <a:xfrm>
            <a:off x="2803680" y="5918040"/>
            <a:ext cx="419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⑥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99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R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HVPGGGSVQIVYK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V…IE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THKLTFRENAK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8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Rectangle 11"/>
          <p:cNvSpPr/>
          <p:nvPr/>
        </p:nvSpPr>
        <p:spPr>
          <a:xfrm>
            <a:off x="2826000" y="5726160"/>
            <a:ext cx="4115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⑤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68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R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HQPGGGKVQIVYK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V…IE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THKLTFRENAK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8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Rectangle 12"/>
          <p:cNvSpPr/>
          <p:nvPr/>
        </p:nvSpPr>
        <p:spPr>
          <a:xfrm>
            <a:off x="2803680" y="5397480"/>
            <a:ext cx="512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④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99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R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HVPGGGSVQIVYK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V…TFRENAKAKTD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HGAEIVYK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9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Rectangle 13"/>
          <p:cNvSpPr/>
          <p:nvPr/>
        </p:nvSpPr>
        <p:spPr>
          <a:xfrm>
            <a:off x="2803680" y="5149800"/>
            <a:ext cx="4792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68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R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HQPGGGKVQIVYK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…..TFRENAKAKTD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HGAEIVYK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9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Rectangle 14"/>
          <p:cNvSpPr/>
          <p:nvPr/>
        </p:nvSpPr>
        <p:spPr>
          <a:xfrm>
            <a:off x="2842200" y="4633920"/>
            <a:ext cx="493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①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68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R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HQPGGGKVQIVY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KP…..DHGAE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IVYK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VV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GD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TS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R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0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Rectangle 15"/>
          <p:cNvSpPr/>
          <p:nvPr/>
        </p:nvSpPr>
        <p:spPr>
          <a:xfrm>
            <a:off x="2828880" y="4824360"/>
            <a:ext cx="493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②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99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R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HVPGGGSVQIVY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KPV…DHGAE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IVYK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VV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GD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TS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R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0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8" name="Picture 20" descr=""/>
          <p:cNvPicPr/>
          <p:nvPr/>
        </p:nvPicPr>
        <p:blipFill>
          <a:blip r:embed="rId1"/>
          <a:stretch/>
        </p:blipFill>
        <p:spPr>
          <a:xfrm>
            <a:off x="1584360" y="5018040"/>
            <a:ext cx="1008000" cy="812880"/>
          </a:xfrm>
          <a:prstGeom prst="rect">
            <a:avLst/>
          </a:prstGeom>
          <a:ln w="0">
            <a:noFill/>
          </a:ln>
        </p:spPr>
      </p:pic>
      <p:grpSp>
        <p:nvGrpSpPr>
          <p:cNvPr id="229" name="図形グループ 4"/>
          <p:cNvGrpSpPr/>
          <p:nvPr/>
        </p:nvGrpSpPr>
        <p:grpSpPr>
          <a:xfrm>
            <a:off x="2503800" y="4863240"/>
            <a:ext cx="367560" cy="1104480"/>
            <a:chOff x="2503800" y="4863240"/>
            <a:chExt cx="367560" cy="1104480"/>
          </a:xfrm>
        </p:grpSpPr>
        <p:sp>
          <p:nvSpPr>
            <p:cNvPr id="230" name="Line 16"/>
            <p:cNvSpPr/>
            <p:nvPr/>
          </p:nvSpPr>
          <p:spPr>
            <a:xfrm flipV="1">
              <a:off x="2515680" y="4863240"/>
              <a:ext cx="320040" cy="341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Line 18"/>
            <p:cNvSpPr/>
            <p:nvPr/>
          </p:nvSpPr>
          <p:spPr>
            <a:xfrm>
              <a:off x="2503800" y="5604840"/>
              <a:ext cx="367560" cy="362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Line 34"/>
            <p:cNvSpPr/>
            <p:nvPr/>
          </p:nvSpPr>
          <p:spPr>
            <a:xfrm>
              <a:off x="2514600" y="5408640"/>
              <a:ext cx="328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33" name="図形グループ 3"/>
          <p:cNvGrpSpPr/>
          <p:nvPr/>
        </p:nvGrpSpPr>
        <p:grpSpPr>
          <a:xfrm>
            <a:off x="6092640" y="4468680"/>
            <a:ext cx="282960" cy="276480"/>
            <a:chOff x="6092640" y="4468680"/>
            <a:chExt cx="282960" cy="276480"/>
          </a:xfrm>
        </p:grpSpPr>
        <p:sp>
          <p:nvSpPr>
            <p:cNvPr id="234" name="テキスト ボックス 1"/>
            <p:cNvSpPr/>
            <p:nvPr/>
          </p:nvSpPr>
          <p:spPr>
            <a:xfrm>
              <a:off x="6092640" y="446868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円/楕円 2"/>
            <p:cNvSpPr/>
            <p:nvPr/>
          </p:nvSpPr>
          <p:spPr>
            <a:xfrm>
              <a:off x="6178320" y="4539960"/>
              <a:ext cx="163800" cy="16848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36" name="図形グループ 22"/>
          <p:cNvGrpSpPr/>
          <p:nvPr/>
        </p:nvGrpSpPr>
        <p:grpSpPr>
          <a:xfrm>
            <a:off x="6499080" y="4468680"/>
            <a:ext cx="282960" cy="276480"/>
            <a:chOff x="6499080" y="4468680"/>
            <a:chExt cx="282960" cy="276480"/>
          </a:xfrm>
        </p:grpSpPr>
        <p:sp>
          <p:nvSpPr>
            <p:cNvPr id="237" name="テキスト ボックス 23"/>
            <p:cNvSpPr/>
            <p:nvPr/>
          </p:nvSpPr>
          <p:spPr>
            <a:xfrm>
              <a:off x="6499080" y="446868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円/楕円 24"/>
            <p:cNvSpPr/>
            <p:nvPr/>
          </p:nvSpPr>
          <p:spPr>
            <a:xfrm>
              <a:off x="6584760" y="4539960"/>
              <a:ext cx="163800" cy="16848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39" name="図形グループ 25"/>
          <p:cNvGrpSpPr/>
          <p:nvPr/>
        </p:nvGrpSpPr>
        <p:grpSpPr>
          <a:xfrm>
            <a:off x="6787440" y="4476600"/>
            <a:ext cx="282960" cy="276480"/>
            <a:chOff x="6787440" y="4476600"/>
            <a:chExt cx="282960" cy="276480"/>
          </a:xfrm>
        </p:grpSpPr>
        <p:sp>
          <p:nvSpPr>
            <p:cNvPr id="240" name="テキスト ボックス 26"/>
            <p:cNvSpPr/>
            <p:nvPr/>
          </p:nvSpPr>
          <p:spPr>
            <a:xfrm>
              <a:off x="6787440" y="447660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円/楕円 27"/>
            <p:cNvSpPr/>
            <p:nvPr/>
          </p:nvSpPr>
          <p:spPr>
            <a:xfrm>
              <a:off x="6881760" y="4538520"/>
              <a:ext cx="162000" cy="16992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42" name="図形グループ 28"/>
          <p:cNvGrpSpPr/>
          <p:nvPr/>
        </p:nvGrpSpPr>
        <p:grpSpPr>
          <a:xfrm>
            <a:off x="6973920" y="4476600"/>
            <a:ext cx="282960" cy="276480"/>
            <a:chOff x="6973920" y="4476600"/>
            <a:chExt cx="282960" cy="276480"/>
          </a:xfrm>
        </p:grpSpPr>
        <p:sp>
          <p:nvSpPr>
            <p:cNvPr id="243" name="テキスト ボックス 29"/>
            <p:cNvSpPr/>
            <p:nvPr/>
          </p:nvSpPr>
          <p:spPr>
            <a:xfrm>
              <a:off x="6973920" y="447660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円/楕円 30"/>
            <p:cNvSpPr/>
            <p:nvPr/>
          </p:nvSpPr>
          <p:spPr>
            <a:xfrm>
              <a:off x="7059600" y="4538520"/>
              <a:ext cx="163440" cy="169920"/>
            </a:xfrm>
            <a:prstGeom prst="ellips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45" name="Rectangle 48"/>
          <p:cNvSpPr/>
          <p:nvPr/>
        </p:nvSpPr>
        <p:spPr>
          <a:xfrm>
            <a:off x="231120" y="114480"/>
            <a:ext cx="1720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Suppl Fig 3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Rectangle 39"/>
          <p:cNvSpPr/>
          <p:nvPr/>
        </p:nvSpPr>
        <p:spPr>
          <a:xfrm>
            <a:off x="1337760" y="452448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47" name="図形グループ 4"/>
          <p:cNvGrpSpPr/>
          <p:nvPr/>
        </p:nvGrpSpPr>
        <p:grpSpPr>
          <a:xfrm>
            <a:off x="1228680" y="816120"/>
            <a:ext cx="7042320" cy="3504960"/>
            <a:chOff x="1228680" y="816120"/>
            <a:chExt cx="7042320" cy="3504960"/>
          </a:xfrm>
        </p:grpSpPr>
        <p:pic>
          <p:nvPicPr>
            <p:cNvPr id="248" name="図 3" descr=""/>
            <p:cNvPicPr/>
            <p:nvPr/>
          </p:nvPicPr>
          <p:blipFill>
            <a:blip r:embed="rId2"/>
            <a:stretch/>
          </p:blipFill>
          <p:spPr>
            <a:xfrm>
              <a:off x="1228680" y="843120"/>
              <a:ext cx="7042320" cy="34779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49" name="Group 44"/>
            <p:cNvGrpSpPr/>
            <p:nvPr/>
          </p:nvGrpSpPr>
          <p:grpSpPr>
            <a:xfrm>
              <a:off x="3435480" y="853920"/>
              <a:ext cx="4601160" cy="580680"/>
              <a:chOff x="3435480" y="853920"/>
              <a:chExt cx="4601160" cy="580680"/>
            </a:xfrm>
          </p:grpSpPr>
          <p:sp>
            <p:nvSpPr>
              <p:cNvPr id="250" name="Rectangle 9"/>
              <p:cNvSpPr/>
              <p:nvPr/>
            </p:nvSpPr>
            <p:spPr>
              <a:xfrm>
                <a:off x="6895800" y="871200"/>
                <a:ext cx="11408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Arial"/>
                    <a:ea typeface="MS PGothic"/>
                  </a:rPr>
                  <a:t>AD (+AP)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1" name="Rectangle 43"/>
              <p:cNvSpPr/>
              <p:nvPr/>
            </p:nvSpPr>
            <p:spPr>
              <a:xfrm>
                <a:off x="3435480" y="853920"/>
                <a:ext cx="104112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Arial"/>
                    <a:ea typeface="MS PGothic"/>
                  </a:rPr>
                  <a:t>AD (- AP)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52" name="Rectangle 19"/>
            <p:cNvSpPr/>
            <p:nvPr/>
          </p:nvSpPr>
          <p:spPr>
            <a:xfrm>
              <a:off x="2846160" y="941400"/>
              <a:ext cx="183960" cy="245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Rectangle 20"/>
            <p:cNvSpPr/>
            <p:nvPr/>
          </p:nvSpPr>
          <p:spPr>
            <a:xfrm>
              <a:off x="1796040" y="101916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Osaka"/>
                </a:rPr>
                <a:t>10447.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Rectangle 21"/>
            <p:cNvSpPr/>
            <p:nvPr/>
          </p:nvSpPr>
          <p:spPr>
            <a:xfrm>
              <a:off x="2574000" y="106992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Osaka"/>
                </a:rPr>
                <a:t>10517.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Line 22"/>
            <p:cNvSpPr/>
            <p:nvPr/>
          </p:nvSpPr>
          <p:spPr>
            <a:xfrm flipV="1">
              <a:off x="2350800" y="2361960"/>
              <a:ext cx="0" cy="185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Rectangle 23"/>
            <p:cNvSpPr/>
            <p:nvPr/>
          </p:nvSpPr>
          <p:spPr>
            <a:xfrm>
              <a:off x="2084040" y="2090880"/>
              <a:ext cx="56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Osaka"/>
                </a:rPr>
                <a:t>9403.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Line 24"/>
            <p:cNvSpPr/>
            <p:nvPr/>
          </p:nvSpPr>
          <p:spPr>
            <a:xfrm flipH="1" flipV="1">
              <a:off x="2171520" y="2530080"/>
              <a:ext cx="126720" cy="104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Rectangle 25"/>
            <p:cNvSpPr/>
            <p:nvPr/>
          </p:nvSpPr>
          <p:spPr>
            <a:xfrm>
              <a:off x="1726920" y="2319480"/>
              <a:ext cx="56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Osaka"/>
                </a:rPr>
                <a:t>9330.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Rectangle 26"/>
            <p:cNvSpPr/>
            <p:nvPr/>
          </p:nvSpPr>
          <p:spPr>
            <a:xfrm>
              <a:off x="5469120" y="969840"/>
              <a:ext cx="183960" cy="245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Rectangle 27"/>
            <p:cNvSpPr/>
            <p:nvPr/>
          </p:nvSpPr>
          <p:spPr>
            <a:xfrm>
              <a:off x="5420520" y="118908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Osaka"/>
                </a:rPr>
                <a:t>10448.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Rectangle 28"/>
            <p:cNvSpPr/>
            <p:nvPr/>
          </p:nvSpPr>
          <p:spPr>
            <a:xfrm>
              <a:off x="6273000" y="113040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Osaka"/>
                </a:rPr>
                <a:t>10517.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Rectangle 29"/>
            <p:cNvSpPr/>
            <p:nvPr/>
          </p:nvSpPr>
          <p:spPr>
            <a:xfrm>
              <a:off x="6187680" y="855720"/>
              <a:ext cx="390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Gothic"/>
                </a:rPr>
                <a:t> ③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Rectangle 30"/>
            <p:cNvSpPr/>
            <p:nvPr/>
          </p:nvSpPr>
          <p:spPr>
            <a:xfrm>
              <a:off x="5435280" y="927000"/>
              <a:ext cx="390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Gothic"/>
                </a:rPr>
                <a:t> ④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Rectangle 31"/>
            <p:cNvSpPr/>
            <p:nvPr/>
          </p:nvSpPr>
          <p:spPr>
            <a:xfrm>
              <a:off x="5352120" y="1924920"/>
              <a:ext cx="39096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Gothic"/>
                </a:rPr>
                <a:t> ⑤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5" name="Rectangle 33"/>
            <p:cNvSpPr/>
            <p:nvPr/>
          </p:nvSpPr>
          <p:spPr>
            <a:xfrm>
              <a:off x="5572080" y="2115000"/>
              <a:ext cx="56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Osaka"/>
                </a:rPr>
                <a:t>9403.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Rectangle 34"/>
            <p:cNvSpPr/>
            <p:nvPr/>
          </p:nvSpPr>
          <p:spPr>
            <a:xfrm>
              <a:off x="5329440" y="2447640"/>
              <a:ext cx="56628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Osaka"/>
                </a:rPr>
                <a:t>9330.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Line 35"/>
            <p:cNvSpPr/>
            <p:nvPr/>
          </p:nvSpPr>
          <p:spPr>
            <a:xfrm>
              <a:off x="5873760" y="2370240"/>
              <a:ext cx="0" cy="287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Rectangle 36"/>
            <p:cNvSpPr/>
            <p:nvPr/>
          </p:nvSpPr>
          <p:spPr>
            <a:xfrm>
              <a:off x="6068160" y="283356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Osaka"/>
                </a:rPr>
                <a:t>11527.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Rectangle 37"/>
            <p:cNvSpPr/>
            <p:nvPr/>
          </p:nvSpPr>
          <p:spPr>
            <a:xfrm>
              <a:off x="6409800" y="299088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Osaka"/>
                </a:rPr>
                <a:t>11597.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Rectangle 38"/>
            <p:cNvSpPr/>
            <p:nvPr/>
          </p:nvSpPr>
          <p:spPr>
            <a:xfrm>
              <a:off x="6489360" y="2759040"/>
              <a:ext cx="390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Gothic"/>
                </a:rPr>
                <a:t> ①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1" name="Rectangle 39"/>
            <p:cNvSpPr/>
            <p:nvPr/>
          </p:nvSpPr>
          <p:spPr>
            <a:xfrm>
              <a:off x="6113160" y="2641680"/>
              <a:ext cx="390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Gothic"/>
                </a:rPr>
                <a:t> ②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Line 40"/>
            <p:cNvSpPr/>
            <p:nvPr/>
          </p:nvSpPr>
          <p:spPr>
            <a:xfrm flipV="1">
              <a:off x="6309000" y="3082680"/>
              <a:ext cx="0" cy="68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Line 41"/>
            <p:cNvSpPr/>
            <p:nvPr/>
          </p:nvSpPr>
          <p:spPr>
            <a:xfrm flipV="1">
              <a:off x="6383520" y="3108240"/>
              <a:ext cx="8064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Rectangle 42"/>
            <p:cNvSpPr/>
            <p:nvPr/>
          </p:nvSpPr>
          <p:spPr>
            <a:xfrm>
              <a:off x="2586960" y="822240"/>
              <a:ext cx="390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Gothic"/>
                </a:rPr>
                <a:t> ③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Rectangle 43"/>
            <p:cNvSpPr/>
            <p:nvPr/>
          </p:nvSpPr>
          <p:spPr>
            <a:xfrm>
              <a:off x="1809000" y="816120"/>
              <a:ext cx="390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Gothic"/>
                </a:rPr>
                <a:t> ④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Rectangle 44"/>
            <p:cNvSpPr/>
            <p:nvPr/>
          </p:nvSpPr>
          <p:spPr>
            <a:xfrm>
              <a:off x="2142360" y="1852560"/>
              <a:ext cx="390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Gothic"/>
                </a:rPr>
                <a:t> ⑤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7" name="Rectangle 45"/>
            <p:cNvSpPr/>
            <p:nvPr/>
          </p:nvSpPr>
          <p:spPr>
            <a:xfrm>
              <a:off x="1767960" y="2100240"/>
              <a:ext cx="390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Gothic"/>
                </a:rPr>
                <a:t> ⑥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Line 47"/>
            <p:cNvSpPr/>
            <p:nvPr/>
          </p:nvSpPr>
          <p:spPr>
            <a:xfrm>
              <a:off x="2401920" y="1187280"/>
              <a:ext cx="123480" cy="66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9" name="Line 48"/>
            <p:cNvSpPr/>
            <p:nvPr/>
          </p:nvSpPr>
          <p:spPr>
            <a:xfrm>
              <a:off x="5899320" y="1397160"/>
              <a:ext cx="15228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Line 49"/>
            <p:cNvSpPr/>
            <p:nvPr/>
          </p:nvSpPr>
          <p:spPr>
            <a:xfrm>
              <a:off x="5753160" y="2635200"/>
              <a:ext cx="7596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Rectangle 32"/>
            <p:cNvSpPr/>
            <p:nvPr/>
          </p:nvSpPr>
          <p:spPr>
            <a:xfrm>
              <a:off x="5246280" y="2223000"/>
              <a:ext cx="39096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Gothic"/>
                </a:rPr>
                <a:t> ⑥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2" name="図形グループ 1"/>
          <p:cNvGrpSpPr/>
          <p:nvPr/>
        </p:nvGrpSpPr>
        <p:grpSpPr>
          <a:xfrm>
            <a:off x="2413080" y="4863960"/>
            <a:ext cx="4865040" cy="689040"/>
            <a:chOff x="2413080" y="4863960"/>
            <a:chExt cx="4865040" cy="689040"/>
          </a:xfrm>
        </p:grpSpPr>
        <p:sp>
          <p:nvSpPr>
            <p:cNvPr id="283" name="Line 6"/>
            <p:cNvSpPr/>
            <p:nvPr/>
          </p:nvSpPr>
          <p:spPr>
            <a:xfrm flipV="1">
              <a:off x="3063960" y="5235120"/>
              <a:ext cx="95040" cy="4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4" name="Rectangle 7"/>
            <p:cNvSpPr/>
            <p:nvPr/>
          </p:nvSpPr>
          <p:spPr>
            <a:xfrm rot="21596400">
              <a:off x="3289320" y="5047920"/>
              <a:ext cx="3988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①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43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3R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Arial"/>
                </a:rPr>
                <a:t>LQTAPVPMPDLK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…E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THKLTFRENAKAK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8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85" name="Picture 9" descr=""/>
            <p:cNvPicPr/>
            <p:nvPr/>
          </p:nvPicPr>
          <p:blipFill>
            <a:blip r:embed="rId1"/>
            <a:stretch/>
          </p:blipFill>
          <p:spPr>
            <a:xfrm>
              <a:off x="2413080" y="4863960"/>
              <a:ext cx="860400" cy="689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86" name="Rectangle 11"/>
            <p:cNvSpPr/>
            <p:nvPr/>
          </p:nvSpPr>
          <p:spPr>
            <a:xfrm>
              <a:off x="2779560" y="5270400"/>
              <a:ext cx="183960" cy="27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7" name="Rectangle 13"/>
            <p:cNvSpPr/>
            <p:nvPr/>
          </p:nvSpPr>
          <p:spPr>
            <a:xfrm rot="21596400">
              <a:off x="3298680" y="5273640"/>
              <a:ext cx="3783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②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43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3R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Arial"/>
                </a:rPr>
                <a:t>LQTAPVPMPDLK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…E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THKLTFRENAK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8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8" name="Line 18"/>
            <p:cNvSpPr/>
            <p:nvPr/>
          </p:nvSpPr>
          <p:spPr>
            <a:xfrm>
              <a:off x="3238560" y="5281560"/>
              <a:ext cx="71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89" name="Rectangle 48"/>
          <p:cNvSpPr/>
          <p:nvPr/>
        </p:nvSpPr>
        <p:spPr>
          <a:xfrm>
            <a:off x="370800" y="139680"/>
            <a:ext cx="1720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Suppl Fig 4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Rectangle 21"/>
          <p:cNvSpPr/>
          <p:nvPr/>
        </p:nvSpPr>
        <p:spPr>
          <a:xfrm>
            <a:off x="1604520" y="464508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91" name="図形グループ 2"/>
          <p:cNvGrpSpPr/>
          <p:nvPr/>
        </p:nvGrpSpPr>
        <p:grpSpPr>
          <a:xfrm>
            <a:off x="1506600" y="1442880"/>
            <a:ext cx="6602400" cy="2971800"/>
            <a:chOff x="1506600" y="1442880"/>
            <a:chExt cx="6602400" cy="2971800"/>
          </a:xfrm>
        </p:grpSpPr>
        <p:grpSp>
          <p:nvGrpSpPr>
            <p:cNvPr id="292" name="図形グループ 1"/>
            <p:cNvGrpSpPr/>
            <p:nvPr/>
          </p:nvGrpSpPr>
          <p:grpSpPr>
            <a:xfrm>
              <a:off x="1506600" y="1442880"/>
              <a:ext cx="6602400" cy="2971800"/>
              <a:chOff x="1506600" y="1442880"/>
              <a:chExt cx="6602400" cy="2971800"/>
            </a:xfrm>
          </p:grpSpPr>
          <p:pic>
            <p:nvPicPr>
              <p:cNvPr id="293" name="図 35" descr=""/>
              <p:cNvPicPr/>
              <p:nvPr/>
            </p:nvPicPr>
            <p:blipFill>
              <a:blip r:embed="rId2"/>
              <a:stretch/>
            </p:blipFill>
            <p:spPr>
              <a:xfrm>
                <a:off x="1506600" y="1678320"/>
                <a:ext cx="6602400" cy="27363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294" name="Group 14"/>
              <p:cNvGrpSpPr/>
              <p:nvPr/>
            </p:nvGrpSpPr>
            <p:grpSpPr>
              <a:xfrm>
                <a:off x="6726600" y="1887120"/>
                <a:ext cx="877320" cy="307080"/>
                <a:chOff x="6726600" y="1887120"/>
                <a:chExt cx="877320" cy="307080"/>
              </a:xfrm>
            </p:grpSpPr>
            <p:sp>
              <p:nvSpPr>
                <p:cNvPr id="295" name="Rectangle 15"/>
                <p:cNvSpPr/>
                <p:nvPr/>
              </p:nvSpPr>
              <p:spPr>
                <a:xfrm>
                  <a:off x="6967440" y="1934640"/>
                  <a:ext cx="6364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Osaka"/>
                    </a:rPr>
                    <a:t>12095.8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6" name="Rectangle 16"/>
                <p:cNvSpPr/>
                <p:nvPr/>
              </p:nvSpPr>
              <p:spPr>
                <a:xfrm>
                  <a:off x="6726600" y="1887120"/>
                  <a:ext cx="39096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MS Gothic"/>
                    </a:rPr>
                    <a:t> ①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97" name="Group 17"/>
              <p:cNvGrpSpPr/>
              <p:nvPr/>
            </p:nvGrpSpPr>
            <p:grpSpPr>
              <a:xfrm>
                <a:off x="6469200" y="1534680"/>
                <a:ext cx="878760" cy="307080"/>
                <a:chOff x="6469200" y="1534680"/>
                <a:chExt cx="878760" cy="307080"/>
              </a:xfrm>
            </p:grpSpPr>
            <p:sp>
              <p:nvSpPr>
                <p:cNvPr id="298" name="Rectangle 18"/>
                <p:cNvSpPr/>
                <p:nvPr/>
              </p:nvSpPr>
              <p:spPr>
                <a:xfrm>
                  <a:off x="6711480" y="1582200"/>
                  <a:ext cx="6364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Osaka"/>
                    </a:rPr>
                    <a:t>11893.8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9" name="Rectangle 19"/>
                <p:cNvSpPr/>
                <p:nvPr/>
              </p:nvSpPr>
              <p:spPr>
                <a:xfrm>
                  <a:off x="6469200" y="1534680"/>
                  <a:ext cx="39096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MS Gothic"/>
                    </a:rPr>
                    <a:t> ②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300" name="Group 20"/>
              <p:cNvGrpSpPr/>
              <p:nvPr/>
            </p:nvGrpSpPr>
            <p:grpSpPr>
              <a:xfrm>
                <a:off x="3328560" y="2203200"/>
                <a:ext cx="885240" cy="307080"/>
                <a:chOff x="3328560" y="2203200"/>
                <a:chExt cx="885240" cy="307080"/>
              </a:xfrm>
            </p:grpSpPr>
            <p:sp>
              <p:nvSpPr>
                <p:cNvPr id="301" name="Rectangle 21"/>
                <p:cNvSpPr/>
                <p:nvPr/>
              </p:nvSpPr>
              <p:spPr>
                <a:xfrm>
                  <a:off x="3577320" y="2234880"/>
                  <a:ext cx="6364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Osaka"/>
                    </a:rPr>
                    <a:t>12097.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2" name="Rectangle 22"/>
                <p:cNvSpPr/>
                <p:nvPr/>
              </p:nvSpPr>
              <p:spPr>
                <a:xfrm>
                  <a:off x="3328560" y="2203200"/>
                  <a:ext cx="39096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MS Gothic"/>
                    </a:rPr>
                    <a:t> ①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303" name="Group 23"/>
              <p:cNvGrpSpPr/>
              <p:nvPr/>
            </p:nvGrpSpPr>
            <p:grpSpPr>
              <a:xfrm>
                <a:off x="3176280" y="1442880"/>
                <a:ext cx="878760" cy="307080"/>
                <a:chOff x="3176280" y="1442880"/>
                <a:chExt cx="878760" cy="307080"/>
              </a:xfrm>
            </p:grpSpPr>
            <p:sp>
              <p:nvSpPr>
                <p:cNvPr id="304" name="Rectangle 24"/>
                <p:cNvSpPr/>
                <p:nvPr/>
              </p:nvSpPr>
              <p:spPr>
                <a:xfrm>
                  <a:off x="3418560" y="1482480"/>
                  <a:ext cx="6364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  <a:ea typeface="Osaka"/>
                    </a:rPr>
                    <a:t>11894.7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5" name="Rectangle 25"/>
                <p:cNvSpPr/>
                <p:nvPr/>
              </p:nvSpPr>
              <p:spPr>
                <a:xfrm>
                  <a:off x="3176280" y="1442880"/>
                  <a:ext cx="39096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MS Gothic"/>
                    </a:rPr>
                    <a:t> ②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306" name="Rectangle 4"/>
            <p:cNvSpPr/>
            <p:nvPr/>
          </p:nvSpPr>
          <p:spPr>
            <a:xfrm>
              <a:off x="5110200" y="1456920"/>
              <a:ext cx="1214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PiD  (+AP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7" name="Rectangle 4"/>
            <p:cNvSpPr/>
            <p:nvPr/>
          </p:nvSpPr>
          <p:spPr>
            <a:xfrm>
              <a:off x="1793880" y="1458720"/>
              <a:ext cx="1155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PiD  (-AP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08" name="Rectangle 20"/>
          <p:cNvSpPr/>
          <p:nvPr/>
        </p:nvSpPr>
        <p:spPr>
          <a:xfrm>
            <a:off x="1023480" y="128124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9" name="図形グループ 22"/>
          <p:cNvGrpSpPr/>
          <p:nvPr/>
        </p:nvGrpSpPr>
        <p:grpSpPr>
          <a:xfrm>
            <a:off x="2104920" y="4684680"/>
            <a:ext cx="4964040" cy="1026000"/>
            <a:chOff x="2104920" y="4684680"/>
            <a:chExt cx="4964040" cy="1026000"/>
          </a:xfrm>
        </p:grpSpPr>
        <p:pic>
          <p:nvPicPr>
            <p:cNvPr id="310" name="Picture 28" descr=""/>
            <p:cNvPicPr/>
            <p:nvPr/>
          </p:nvPicPr>
          <p:blipFill>
            <a:blip r:embed="rId1"/>
            <a:stretch/>
          </p:blipFill>
          <p:spPr>
            <a:xfrm>
              <a:off x="2104920" y="4824360"/>
              <a:ext cx="761760" cy="687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11" name="Rectangle 37"/>
            <p:cNvSpPr/>
            <p:nvPr/>
          </p:nvSpPr>
          <p:spPr>
            <a:xfrm>
              <a:off x="2963520" y="4684680"/>
              <a:ext cx="4105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①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68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R </a:t>
              </a: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Arial"/>
                </a:rPr>
                <a:t>HQPGGGK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…NAKAKTD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HGAEIVYK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9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2" name="Line 38"/>
            <p:cNvSpPr/>
            <p:nvPr/>
          </p:nvSpPr>
          <p:spPr>
            <a:xfrm flipV="1">
              <a:off x="2892240" y="4845960"/>
              <a:ext cx="115920" cy="156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3" name="Line 39"/>
            <p:cNvSpPr/>
            <p:nvPr/>
          </p:nvSpPr>
          <p:spPr>
            <a:xfrm>
              <a:off x="2892240" y="5230800"/>
              <a:ext cx="1076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4" name="Line 40"/>
            <p:cNvSpPr/>
            <p:nvPr/>
          </p:nvSpPr>
          <p:spPr>
            <a:xfrm>
              <a:off x="2891520" y="5390640"/>
              <a:ext cx="128160" cy="146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5" name="Rectangle 53"/>
            <p:cNvSpPr/>
            <p:nvPr/>
          </p:nvSpPr>
          <p:spPr>
            <a:xfrm>
              <a:off x="2963520" y="5065560"/>
              <a:ext cx="3764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②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68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R </a:t>
              </a: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Arial"/>
                </a:rPr>
                <a:t>HQPGGGK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…E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THKLTFRENAKAK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87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6" name="Rectangle 54"/>
            <p:cNvSpPr/>
            <p:nvPr/>
          </p:nvSpPr>
          <p:spPr>
            <a:xfrm>
              <a:off x="2963520" y="5434200"/>
              <a:ext cx="3505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③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68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R </a:t>
              </a: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Arial"/>
                </a:rPr>
                <a:t>HQPGGGK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…D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NITHVPGGGNK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6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17" name="Rectangle 48"/>
          <p:cNvSpPr/>
          <p:nvPr/>
        </p:nvSpPr>
        <p:spPr>
          <a:xfrm>
            <a:off x="370800" y="139680"/>
            <a:ext cx="1720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Suppl Fig 5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18" name="図形グループ 1"/>
          <p:cNvGrpSpPr/>
          <p:nvPr/>
        </p:nvGrpSpPr>
        <p:grpSpPr>
          <a:xfrm>
            <a:off x="2816280" y="1082520"/>
            <a:ext cx="3686040" cy="3278520"/>
            <a:chOff x="2816280" y="1082520"/>
            <a:chExt cx="3686040" cy="3278520"/>
          </a:xfrm>
        </p:grpSpPr>
        <p:pic>
          <p:nvPicPr>
            <p:cNvPr id="319" name="Picture 2" descr=""/>
            <p:cNvPicPr/>
            <p:nvPr/>
          </p:nvPicPr>
          <p:blipFill>
            <a:blip r:embed="rId2"/>
            <a:stretch/>
          </p:blipFill>
          <p:spPr>
            <a:xfrm>
              <a:off x="2816280" y="1184040"/>
              <a:ext cx="3686040" cy="31770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320" name="Group 14"/>
            <p:cNvGrpSpPr/>
            <p:nvPr/>
          </p:nvGrpSpPr>
          <p:grpSpPr>
            <a:xfrm>
              <a:off x="4005360" y="1275120"/>
              <a:ext cx="884520" cy="466920"/>
              <a:chOff x="4005360" y="1275120"/>
              <a:chExt cx="884520" cy="466920"/>
            </a:xfrm>
          </p:grpSpPr>
          <p:sp>
            <p:nvSpPr>
              <p:cNvPr id="321" name="Rectangle 15"/>
              <p:cNvSpPr/>
              <p:nvPr/>
            </p:nvSpPr>
            <p:spPr>
              <a:xfrm>
                <a:off x="4154400" y="1465560"/>
                <a:ext cx="73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Osaka"/>
                  </a:rPr>
                  <a:t>10750.1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2" name="Rectangle 16"/>
              <p:cNvSpPr/>
              <p:nvPr/>
            </p:nvSpPr>
            <p:spPr>
              <a:xfrm>
                <a:off x="4005360" y="1275120"/>
                <a:ext cx="3909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Gothic"/>
                  </a:rPr>
                  <a:t> ③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323" name="Group 17"/>
            <p:cNvGrpSpPr/>
            <p:nvPr/>
          </p:nvGrpSpPr>
          <p:grpSpPr>
            <a:xfrm>
              <a:off x="4271760" y="2332080"/>
              <a:ext cx="735480" cy="514440"/>
              <a:chOff x="4271760" y="2332080"/>
              <a:chExt cx="735480" cy="514440"/>
            </a:xfrm>
          </p:grpSpPr>
          <p:sp>
            <p:nvSpPr>
              <p:cNvPr id="324" name="Rectangle 18"/>
              <p:cNvSpPr/>
              <p:nvPr/>
            </p:nvSpPr>
            <p:spPr>
              <a:xfrm>
                <a:off x="4271760" y="2570040"/>
                <a:ext cx="73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Osaka"/>
                  </a:rPr>
                  <a:t>12647.3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5" name="Rectangle 19"/>
              <p:cNvSpPr/>
              <p:nvPr/>
            </p:nvSpPr>
            <p:spPr>
              <a:xfrm>
                <a:off x="4328640" y="2332080"/>
                <a:ext cx="3909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Gothic"/>
                  </a:rPr>
                  <a:t> ②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326" name="Group 20"/>
            <p:cNvGrpSpPr/>
            <p:nvPr/>
          </p:nvGrpSpPr>
          <p:grpSpPr>
            <a:xfrm>
              <a:off x="4734360" y="2050560"/>
              <a:ext cx="768960" cy="500400"/>
              <a:chOff x="4734360" y="2050560"/>
              <a:chExt cx="768960" cy="500400"/>
            </a:xfrm>
          </p:grpSpPr>
          <p:sp>
            <p:nvSpPr>
              <p:cNvPr id="327" name="Rectangle 21"/>
              <p:cNvSpPr/>
              <p:nvPr/>
            </p:nvSpPr>
            <p:spPr>
              <a:xfrm>
                <a:off x="4767840" y="2274480"/>
                <a:ext cx="73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Osaka"/>
                  </a:rPr>
                  <a:t>13757.9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8" name="Rectangle 22"/>
              <p:cNvSpPr/>
              <p:nvPr/>
            </p:nvSpPr>
            <p:spPr>
              <a:xfrm>
                <a:off x="4734360" y="2050560"/>
                <a:ext cx="3909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Gothic"/>
                  </a:rPr>
                  <a:t> ①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29" name="Rectangle 143"/>
            <p:cNvSpPr/>
            <p:nvPr/>
          </p:nvSpPr>
          <p:spPr>
            <a:xfrm>
              <a:off x="4908600" y="1082520"/>
              <a:ext cx="140472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BD (- AP)</a:t>
              </a:r>
              <a:r>
                <a:rPr b="0" lang="ja-JP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　　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30" name="Rectangle 146"/>
          <p:cNvSpPr/>
          <p:nvPr/>
        </p:nvSpPr>
        <p:spPr>
          <a:xfrm>
            <a:off x="2242800" y="422748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Rectangle 145"/>
          <p:cNvSpPr/>
          <p:nvPr/>
        </p:nvSpPr>
        <p:spPr>
          <a:xfrm>
            <a:off x="2276280" y="112716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2" name="Rectangle 53"/>
          <p:cNvSpPr/>
          <p:nvPr/>
        </p:nvSpPr>
        <p:spPr>
          <a:xfrm>
            <a:off x="2041200" y="118116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Rectangle 54"/>
          <p:cNvSpPr/>
          <p:nvPr/>
        </p:nvSpPr>
        <p:spPr>
          <a:xfrm>
            <a:off x="1593360" y="431784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34" name="図形グループ 1"/>
          <p:cNvGrpSpPr/>
          <p:nvPr/>
        </p:nvGrpSpPr>
        <p:grpSpPr>
          <a:xfrm>
            <a:off x="1603440" y="4753080"/>
            <a:ext cx="5643360" cy="1089000"/>
            <a:chOff x="1603440" y="4753080"/>
            <a:chExt cx="5643360" cy="1089000"/>
          </a:xfrm>
        </p:grpSpPr>
        <p:sp>
          <p:nvSpPr>
            <p:cNvPr id="335" name="Line 38"/>
            <p:cNvSpPr/>
            <p:nvPr/>
          </p:nvSpPr>
          <p:spPr>
            <a:xfrm flipV="1">
              <a:off x="2436480" y="4930560"/>
              <a:ext cx="213120" cy="133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6" name="Line 39"/>
            <p:cNvSpPr/>
            <p:nvPr/>
          </p:nvSpPr>
          <p:spPr>
            <a:xfrm>
              <a:off x="2425680" y="5146560"/>
              <a:ext cx="1713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7" name="Line 40"/>
            <p:cNvSpPr/>
            <p:nvPr/>
          </p:nvSpPr>
          <p:spPr>
            <a:xfrm>
              <a:off x="2436480" y="5241240"/>
              <a:ext cx="240120" cy="466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338" name="Picture 41" descr=""/>
            <p:cNvPicPr/>
            <p:nvPr/>
          </p:nvPicPr>
          <p:blipFill>
            <a:blip r:embed="rId1"/>
            <a:stretch/>
          </p:blipFill>
          <p:spPr>
            <a:xfrm>
              <a:off x="1603440" y="4753080"/>
              <a:ext cx="796680" cy="1089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39" name="Rectangle 42"/>
            <p:cNvSpPr/>
            <p:nvPr/>
          </p:nvSpPr>
          <p:spPr>
            <a:xfrm>
              <a:off x="2641680" y="5562720"/>
              <a:ext cx="4089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③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43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R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LQTAPVPMPDLK…SLD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NITHVPGGGNK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6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0" name="Rectangle 55"/>
            <p:cNvSpPr/>
            <p:nvPr/>
          </p:nvSpPr>
          <p:spPr>
            <a:xfrm>
              <a:off x="2641680" y="4775040"/>
              <a:ext cx="4605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①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60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R</a:t>
              </a:r>
              <a:r>
                <a:rPr b="0" lang="en-US" sz="1200" spc="-1" strike="noStrike">
                  <a:solidFill>
                    <a:srgbClr val="333399"/>
                  </a:solidFill>
                  <a:latin typeface="Arial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IGSTENLKHQPGG…TFRENAKAKTD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HGAEIVYK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9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1" name="Rectangle 56"/>
            <p:cNvSpPr/>
            <p:nvPr/>
          </p:nvSpPr>
          <p:spPr>
            <a:xfrm>
              <a:off x="2641680" y="5038560"/>
              <a:ext cx="4605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②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68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R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QPGGGKVQIINK…TFRENAKAKTD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HGAEIVYK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9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42" name="Rectangle 48"/>
          <p:cNvSpPr/>
          <p:nvPr/>
        </p:nvSpPr>
        <p:spPr>
          <a:xfrm>
            <a:off x="370800" y="139680"/>
            <a:ext cx="1720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Suppl Fig 6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43" name="図形グループ 2"/>
          <p:cNvGrpSpPr/>
          <p:nvPr/>
        </p:nvGrpSpPr>
        <p:grpSpPr>
          <a:xfrm>
            <a:off x="2630520" y="1236600"/>
            <a:ext cx="3895560" cy="3357720"/>
            <a:chOff x="2630520" y="1236600"/>
            <a:chExt cx="3895560" cy="3357720"/>
          </a:xfrm>
        </p:grpSpPr>
        <p:pic>
          <p:nvPicPr>
            <p:cNvPr id="344" name="図 13" descr=""/>
            <p:cNvPicPr/>
            <p:nvPr/>
          </p:nvPicPr>
          <p:blipFill>
            <a:blip r:embed="rId2"/>
            <a:stretch/>
          </p:blipFill>
          <p:spPr>
            <a:xfrm>
              <a:off x="2630520" y="1236600"/>
              <a:ext cx="3895560" cy="33577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345" name="Group 19"/>
            <p:cNvGrpSpPr/>
            <p:nvPr/>
          </p:nvGrpSpPr>
          <p:grpSpPr>
            <a:xfrm>
              <a:off x="4194360" y="1456200"/>
              <a:ext cx="916200" cy="458640"/>
              <a:chOff x="4194360" y="1456200"/>
              <a:chExt cx="916200" cy="458640"/>
            </a:xfrm>
          </p:grpSpPr>
          <p:sp>
            <p:nvSpPr>
              <p:cNvPr id="346" name="Rectangle 20"/>
              <p:cNvSpPr/>
              <p:nvPr/>
            </p:nvSpPr>
            <p:spPr>
              <a:xfrm>
                <a:off x="4375080" y="1638360"/>
                <a:ext cx="73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Osaka"/>
                  </a:rPr>
                  <a:t>13569.1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7" name="Rectangle 21"/>
              <p:cNvSpPr/>
              <p:nvPr/>
            </p:nvSpPr>
            <p:spPr>
              <a:xfrm>
                <a:off x="4194360" y="1456200"/>
                <a:ext cx="3909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Gothic"/>
                  </a:rPr>
                  <a:t> ③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348" name="Group 22"/>
            <p:cNvGrpSpPr/>
            <p:nvPr/>
          </p:nvGrpSpPr>
          <p:grpSpPr>
            <a:xfrm>
              <a:off x="4323960" y="2221560"/>
              <a:ext cx="821520" cy="490680"/>
              <a:chOff x="4323960" y="2221560"/>
              <a:chExt cx="821520" cy="490680"/>
            </a:xfrm>
          </p:grpSpPr>
          <p:sp>
            <p:nvSpPr>
              <p:cNvPr id="349" name="Rectangle 23"/>
              <p:cNvSpPr/>
              <p:nvPr/>
            </p:nvSpPr>
            <p:spPr>
              <a:xfrm>
                <a:off x="4410000" y="2435760"/>
                <a:ext cx="73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Osaka"/>
                  </a:rPr>
                  <a:t>13760.4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0" name="Rectangle 24"/>
              <p:cNvSpPr/>
              <p:nvPr/>
            </p:nvSpPr>
            <p:spPr>
              <a:xfrm>
                <a:off x="4323960" y="2221560"/>
                <a:ext cx="3909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Gothic"/>
                  </a:rPr>
                  <a:t> ②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351" name="Group 25"/>
            <p:cNvGrpSpPr/>
            <p:nvPr/>
          </p:nvGrpSpPr>
          <p:grpSpPr>
            <a:xfrm>
              <a:off x="4535280" y="2628000"/>
              <a:ext cx="995400" cy="458640"/>
              <a:chOff x="4535280" y="2628000"/>
              <a:chExt cx="995400" cy="458640"/>
            </a:xfrm>
          </p:grpSpPr>
          <p:sp>
            <p:nvSpPr>
              <p:cNvPr id="352" name="Rectangle 26"/>
              <p:cNvSpPr/>
              <p:nvPr/>
            </p:nvSpPr>
            <p:spPr>
              <a:xfrm>
                <a:off x="4795200" y="2810160"/>
                <a:ext cx="73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Osaka"/>
                  </a:rPr>
                  <a:t>14599.7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3" name="Rectangle 27"/>
              <p:cNvSpPr/>
              <p:nvPr/>
            </p:nvSpPr>
            <p:spPr>
              <a:xfrm>
                <a:off x="4535280" y="2628000"/>
                <a:ext cx="4917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Gothic"/>
                  </a:rPr>
                  <a:t>   ①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54" name="Rectangle 52"/>
            <p:cNvSpPr/>
            <p:nvPr/>
          </p:nvSpPr>
          <p:spPr>
            <a:xfrm>
              <a:off x="5091120" y="1269720"/>
              <a:ext cx="1312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PSP (-AP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5" name="Rectangle 52"/>
          <p:cNvSpPr/>
          <p:nvPr/>
        </p:nvSpPr>
        <p:spPr>
          <a:xfrm>
            <a:off x="2104560" y="80964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Rectangle 53"/>
          <p:cNvSpPr/>
          <p:nvPr/>
        </p:nvSpPr>
        <p:spPr>
          <a:xfrm>
            <a:off x="1945800" y="425124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57" name="図形グループ 2"/>
          <p:cNvGrpSpPr/>
          <p:nvPr/>
        </p:nvGrpSpPr>
        <p:grpSpPr>
          <a:xfrm>
            <a:off x="1700280" y="4708440"/>
            <a:ext cx="5748120" cy="1263960"/>
            <a:chOff x="1700280" y="4708440"/>
            <a:chExt cx="5748120" cy="1263960"/>
          </a:xfrm>
        </p:grpSpPr>
        <p:pic>
          <p:nvPicPr>
            <p:cNvPr id="358" name="Picture 14" descr=""/>
            <p:cNvPicPr/>
            <p:nvPr/>
          </p:nvPicPr>
          <p:blipFill>
            <a:blip r:embed="rId1"/>
            <a:stretch/>
          </p:blipFill>
          <p:spPr>
            <a:xfrm>
              <a:off x="1700280" y="4879800"/>
              <a:ext cx="744480" cy="959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59" name="Rectangle 15"/>
            <p:cNvSpPr/>
            <p:nvPr/>
          </p:nvSpPr>
          <p:spPr>
            <a:xfrm>
              <a:off x="2728800" y="4998960"/>
              <a:ext cx="4719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②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68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R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QPGGGKVQIINK…LTFRENAKAKTD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HGAEIVYK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9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0" name="Line 16"/>
            <p:cNvSpPr/>
            <p:nvPr/>
          </p:nvSpPr>
          <p:spPr>
            <a:xfrm flipV="1">
              <a:off x="2472120" y="5177520"/>
              <a:ext cx="246960" cy="111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1" name="Line 17"/>
            <p:cNvSpPr/>
            <p:nvPr/>
          </p:nvSpPr>
          <p:spPr>
            <a:xfrm>
              <a:off x="2471760" y="5419800"/>
              <a:ext cx="257040" cy="109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2" name="Line 18"/>
            <p:cNvSpPr/>
            <p:nvPr/>
          </p:nvSpPr>
          <p:spPr>
            <a:xfrm>
              <a:off x="2471760" y="5583960"/>
              <a:ext cx="257040" cy="238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3" name="Rectangle 20"/>
            <p:cNvSpPr/>
            <p:nvPr/>
          </p:nvSpPr>
          <p:spPr>
            <a:xfrm>
              <a:off x="2728800" y="5365800"/>
              <a:ext cx="4484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③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68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R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QPGGGKVQIINK…E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THKLTFRENAKAK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87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4" name="Rectangle 21"/>
            <p:cNvSpPr/>
            <p:nvPr/>
          </p:nvSpPr>
          <p:spPr>
            <a:xfrm>
              <a:off x="2728800" y="5695920"/>
              <a:ext cx="4365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④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68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R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QPGGGKVQIINK…D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NITHVPGGGNK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6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5" name="Line 24"/>
            <p:cNvSpPr/>
            <p:nvPr/>
          </p:nvSpPr>
          <p:spPr>
            <a:xfrm flipV="1">
              <a:off x="2471760" y="4889880"/>
              <a:ext cx="310680" cy="308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6" name="Rectangle 25"/>
            <p:cNvSpPr/>
            <p:nvPr/>
          </p:nvSpPr>
          <p:spPr>
            <a:xfrm>
              <a:off x="2728800" y="4708440"/>
              <a:ext cx="4719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①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60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R</a:t>
              </a:r>
              <a:r>
                <a:rPr b="0" lang="en-US" sz="1200" spc="-1" strike="noStrike">
                  <a:solidFill>
                    <a:srgbClr val="333399"/>
                  </a:solidFill>
                  <a:latin typeface="Arial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IGSTENLKHQPGG…LTFRENAKAKTD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HGAEIVYK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9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67" name="Rectangle 48"/>
          <p:cNvSpPr/>
          <p:nvPr/>
        </p:nvSpPr>
        <p:spPr>
          <a:xfrm>
            <a:off x="370800" y="139680"/>
            <a:ext cx="1720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Suppl Fig 7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68" name="図形グループ 1"/>
          <p:cNvGrpSpPr/>
          <p:nvPr/>
        </p:nvGrpSpPr>
        <p:grpSpPr>
          <a:xfrm>
            <a:off x="2612880" y="888840"/>
            <a:ext cx="4021200" cy="3546720"/>
            <a:chOff x="2612880" y="888840"/>
            <a:chExt cx="4021200" cy="3546720"/>
          </a:xfrm>
        </p:grpSpPr>
        <p:pic>
          <p:nvPicPr>
            <p:cNvPr id="369" name="Picture 2" descr=""/>
            <p:cNvPicPr/>
            <p:nvPr/>
          </p:nvPicPr>
          <p:blipFill>
            <a:blip r:embed="rId2">
              <a:lum bright="6000"/>
            </a:blip>
            <a:stretch/>
          </p:blipFill>
          <p:spPr>
            <a:xfrm>
              <a:off x="2612880" y="953640"/>
              <a:ext cx="3978360" cy="3481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70" name="Rectangle 3"/>
            <p:cNvSpPr/>
            <p:nvPr/>
          </p:nvSpPr>
          <p:spPr>
            <a:xfrm>
              <a:off x="4721040" y="888840"/>
              <a:ext cx="1913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Osaka"/>
                </a:rPr>
                <a:t>CBD+PSP (-AP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371" name="Group 19"/>
            <p:cNvGrpSpPr/>
            <p:nvPr/>
          </p:nvGrpSpPr>
          <p:grpSpPr>
            <a:xfrm>
              <a:off x="4750920" y="1666800"/>
              <a:ext cx="813240" cy="514440"/>
              <a:chOff x="4750920" y="1666800"/>
              <a:chExt cx="813240" cy="514440"/>
            </a:xfrm>
          </p:grpSpPr>
          <p:sp>
            <p:nvSpPr>
              <p:cNvPr id="372" name="Rectangle 20"/>
              <p:cNvSpPr/>
              <p:nvPr/>
            </p:nvSpPr>
            <p:spPr>
              <a:xfrm>
                <a:off x="4828680" y="1904760"/>
                <a:ext cx="73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Osaka"/>
                  </a:rPr>
                  <a:t>13760.7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3" name="Rectangle 21"/>
              <p:cNvSpPr/>
              <p:nvPr/>
            </p:nvSpPr>
            <p:spPr>
              <a:xfrm>
                <a:off x="4750920" y="1666800"/>
                <a:ext cx="3909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Gothic"/>
                  </a:rPr>
                  <a:t> ②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374" name="Group 22"/>
            <p:cNvGrpSpPr/>
            <p:nvPr/>
          </p:nvGrpSpPr>
          <p:grpSpPr>
            <a:xfrm>
              <a:off x="4965480" y="2741760"/>
              <a:ext cx="868320" cy="514800"/>
              <a:chOff x="4965480" y="2741760"/>
              <a:chExt cx="868320" cy="514800"/>
            </a:xfrm>
          </p:grpSpPr>
          <p:sp>
            <p:nvSpPr>
              <p:cNvPr id="375" name="Rectangle 23"/>
              <p:cNvSpPr/>
              <p:nvPr/>
            </p:nvSpPr>
            <p:spPr>
              <a:xfrm>
                <a:off x="5098320" y="2980080"/>
                <a:ext cx="73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Osaka"/>
                  </a:rPr>
                  <a:t>14605.3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6" name="Rectangle 24"/>
              <p:cNvSpPr/>
              <p:nvPr/>
            </p:nvSpPr>
            <p:spPr>
              <a:xfrm>
                <a:off x="4965480" y="2741760"/>
                <a:ext cx="4413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Gothic"/>
                  </a:rPr>
                  <a:t>  ①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377" name="Group 25"/>
            <p:cNvGrpSpPr/>
            <p:nvPr/>
          </p:nvGrpSpPr>
          <p:grpSpPr>
            <a:xfrm>
              <a:off x="3795120" y="910800"/>
              <a:ext cx="940320" cy="451080"/>
              <a:chOff x="3795120" y="910800"/>
              <a:chExt cx="940320" cy="451080"/>
            </a:xfrm>
          </p:grpSpPr>
          <p:sp>
            <p:nvSpPr>
              <p:cNvPr id="378" name="Rectangle 26"/>
              <p:cNvSpPr/>
              <p:nvPr/>
            </p:nvSpPr>
            <p:spPr>
              <a:xfrm>
                <a:off x="3999960" y="1085400"/>
                <a:ext cx="73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Osaka"/>
                  </a:rPr>
                  <a:t>10751.1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79" name="Rectangle 27"/>
              <p:cNvSpPr/>
              <p:nvPr/>
            </p:nvSpPr>
            <p:spPr>
              <a:xfrm>
                <a:off x="3795120" y="910800"/>
                <a:ext cx="3909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Gothic"/>
                  </a:rPr>
                  <a:t> ④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380" name="Group 28"/>
            <p:cNvGrpSpPr/>
            <p:nvPr/>
          </p:nvGrpSpPr>
          <p:grpSpPr>
            <a:xfrm>
              <a:off x="4277880" y="2203560"/>
              <a:ext cx="735480" cy="538560"/>
              <a:chOff x="4277880" y="2203560"/>
              <a:chExt cx="735480" cy="538560"/>
            </a:xfrm>
          </p:grpSpPr>
          <p:sp>
            <p:nvSpPr>
              <p:cNvPr id="381" name="Rectangle 29"/>
              <p:cNvSpPr/>
              <p:nvPr/>
            </p:nvSpPr>
            <p:spPr>
              <a:xfrm>
                <a:off x="4277880" y="2465640"/>
                <a:ext cx="735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Osaka"/>
                  </a:rPr>
                  <a:t>12647.5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82" name="Rectangle 30"/>
              <p:cNvSpPr/>
              <p:nvPr/>
            </p:nvSpPr>
            <p:spPr>
              <a:xfrm>
                <a:off x="4398480" y="2203560"/>
                <a:ext cx="3909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Gothic"/>
                  </a:rPr>
                  <a:t> ③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Rectangle 43"/>
          <p:cNvSpPr/>
          <p:nvPr/>
        </p:nvSpPr>
        <p:spPr>
          <a:xfrm>
            <a:off x="1068480" y="4165560"/>
            <a:ext cx="422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84" name="図形グループ 1"/>
          <p:cNvGrpSpPr/>
          <p:nvPr/>
        </p:nvGrpSpPr>
        <p:grpSpPr>
          <a:xfrm>
            <a:off x="1415520" y="4287960"/>
            <a:ext cx="6861600" cy="1997280"/>
            <a:chOff x="1415520" y="4287960"/>
            <a:chExt cx="6861600" cy="1997280"/>
          </a:xfrm>
        </p:grpSpPr>
        <p:sp>
          <p:nvSpPr>
            <p:cNvPr id="385" name="Rectangle 12"/>
            <p:cNvSpPr/>
            <p:nvPr/>
          </p:nvSpPr>
          <p:spPr>
            <a:xfrm>
              <a:off x="2486160" y="5103720"/>
              <a:ext cx="5181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③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68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4R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HQPGGGKVQI…NKKIETHKLTFRENAKAKTD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HGAEIVYK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9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6" name="Line 13"/>
            <p:cNvSpPr/>
            <p:nvPr/>
          </p:nvSpPr>
          <p:spPr>
            <a:xfrm>
              <a:off x="2260800" y="5532840"/>
              <a:ext cx="217080" cy="18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7" name="Line 14"/>
            <p:cNvSpPr/>
            <p:nvPr/>
          </p:nvSpPr>
          <p:spPr>
            <a:xfrm>
              <a:off x="2260440" y="5583240"/>
              <a:ext cx="291960" cy="199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8" name="Line 15"/>
            <p:cNvSpPr/>
            <p:nvPr/>
          </p:nvSpPr>
          <p:spPr>
            <a:xfrm>
              <a:off x="2243160" y="5696640"/>
              <a:ext cx="313920" cy="401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9" name="Rectangle 17"/>
            <p:cNvSpPr/>
            <p:nvPr/>
          </p:nvSpPr>
          <p:spPr>
            <a:xfrm>
              <a:off x="2486160" y="5419800"/>
              <a:ext cx="4230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④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68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R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HQPGGGKVQI…NKKIE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THKLTFRENAKAK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8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0" name="Rectangle 18"/>
            <p:cNvSpPr/>
            <p:nvPr/>
          </p:nvSpPr>
          <p:spPr>
            <a:xfrm>
              <a:off x="2486160" y="6008760"/>
              <a:ext cx="4286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⑥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68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R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QPGGGKVQI…GSLD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NITHVPGGGNK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6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1" name="Line 21"/>
            <p:cNvSpPr/>
            <p:nvPr/>
          </p:nvSpPr>
          <p:spPr>
            <a:xfrm flipV="1">
              <a:off x="2246400" y="4617720"/>
              <a:ext cx="307440" cy="431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2" name="Rectangle 22"/>
            <p:cNvSpPr/>
            <p:nvPr/>
          </p:nvSpPr>
          <p:spPr>
            <a:xfrm>
              <a:off x="2486160" y="4761000"/>
              <a:ext cx="579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②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60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R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IGSTENLKHQPGGGK…NKKIETHKLTFRENAKAKTD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HGAEIVYK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9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3" name="Rectangle 26"/>
            <p:cNvSpPr/>
            <p:nvPr/>
          </p:nvSpPr>
          <p:spPr>
            <a:xfrm>
              <a:off x="2486160" y="5678640"/>
              <a:ext cx="4505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⑤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60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R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IGSTENLKHQPGGGK…GSLD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NITHVPGGGNK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6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4" name="Rectangle 27"/>
            <p:cNvSpPr/>
            <p:nvPr/>
          </p:nvSpPr>
          <p:spPr>
            <a:xfrm>
              <a:off x="2486160" y="4456080"/>
              <a:ext cx="579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①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60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R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IGSTENLKHQPGGGK…RENAKAKTDHGAE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IVYK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S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PVV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S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GD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TS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PR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5" name="Line 28"/>
            <p:cNvSpPr/>
            <p:nvPr/>
          </p:nvSpPr>
          <p:spPr>
            <a:xfrm flipV="1">
              <a:off x="2249280" y="5259240"/>
              <a:ext cx="252720" cy="11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280" bIns="-35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6" name="Line 29"/>
            <p:cNvSpPr/>
            <p:nvPr/>
          </p:nvSpPr>
          <p:spPr>
            <a:xfrm flipV="1">
              <a:off x="2248200" y="4904280"/>
              <a:ext cx="268920" cy="298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397" name="図 1" descr=""/>
            <p:cNvPicPr/>
            <p:nvPr/>
          </p:nvPicPr>
          <p:blipFill>
            <a:blip r:embed="rId1"/>
            <a:stretch/>
          </p:blipFill>
          <p:spPr>
            <a:xfrm>
              <a:off x="1798560" y="4764600"/>
              <a:ext cx="406080" cy="10918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398" name="図形グループ 2"/>
            <p:cNvGrpSpPr/>
            <p:nvPr/>
          </p:nvGrpSpPr>
          <p:grpSpPr>
            <a:xfrm>
              <a:off x="1415520" y="4894560"/>
              <a:ext cx="412560" cy="915480"/>
              <a:chOff x="1415520" y="4894560"/>
              <a:chExt cx="412560" cy="915480"/>
            </a:xfrm>
          </p:grpSpPr>
          <p:sp>
            <p:nvSpPr>
              <p:cNvPr id="399" name="Rectangle 60"/>
              <p:cNvSpPr/>
              <p:nvPr/>
            </p:nvSpPr>
            <p:spPr>
              <a:xfrm>
                <a:off x="1426320" y="5148360"/>
                <a:ext cx="401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MS PGothic"/>
                  </a:rPr>
                  <a:t>15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0" name="Rectangle 62"/>
              <p:cNvSpPr/>
              <p:nvPr/>
            </p:nvSpPr>
            <p:spPr>
              <a:xfrm>
                <a:off x="1415520" y="4894560"/>
                <a:ext cx="401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MS PGothic"/>
                  </a:rPr>
                  <a:t>17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1" name="Rectangle 63"/>
              <p:cNvSpPr/>
              <p:nvPr/>
            </p:nvSpPr>
            <p:spPr>
              <a:xfrm>
                <a:off x="1426320" y="5033880"/>
                <a:ext cx="401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MS PGothic"/>
                  </a:rPr>
                  <a:t>16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2" name="Rectangle 64"/>
              <p:cNvSpPr/>
              <p:nvPr/>
            </p:nvSpPr>
            <p:spPr>
              <a:xfrm>
                <a:off x="1415520" y="5330520"/>
                <a:ext cx="401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MS PGothic"/>
                  </a:rPr>
                  <a:t>13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3" name="Rectangle 65"/>
              <p:cNvSpPr/>
              <p:nvPr/>
            </p:nvSpPr>
            <p:spPr>
              <a:xfrm>
                <a:off x="1426320" y="5533560"/>
                <a:ext cx="401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MS PGothic"/>
                  </a:rPr>
                  <a:t>10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04" name="図形グループ 28"/>
            <p:cNvGrpSpPr/>
            <p:nvPr/>
          </p:nvGrpSpPr>
          <p:grpSpPr>
            <a:xfrm>
              <a:off x="6636960" y="4287960"/>
              <a:ext cx="282960" cy="276480"/>
              <a:chOff x="6636960" y="4287960"/>
              <a:chExt cx="282960" cy="276480"/>
            </a:xfrm>
          </p:grpSpPr>
          <p:sp>
            <p:nvSpPr>
              <p:cNvPr id="405" name="テキスト ボックス 29"/>
              <p:cNvSpPr/>
              <p:nvPr/>
            </p:nvSpPr>
            <p:spPr>
              <a:xfrm>
                <a:off x="6636960" y="4287960"/>
                <a:ext cx="282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6" name="円/楕円 30"/>
              <p:cNvSpPr/>
              <p:nvPr/>
            </p:nvSpPr>
            <p:spPr>
              <a:xfrm>
                <a:off x="6684840" y="4338720"/>
                <a:ext cx="179280" cy="17928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07" name="図形グループ 31"/>
            <p:cNvGrpSpPr/>
            <p:nvPr/>
          </p:nvGrpSpPr>
          <p:grpSpPr>
            <a:xfrm>
              <a:off x="7051680" y="4287960"/>
              <a:ext cx="282960" cy="276480"/>
              <a:chOff x="7051680" y="4287960"/>
              <a:chExt cx="282960" cy="276480"/>
            </a:xfrm>
          </p:grpSpPr>
          <p:sp>
            <p:nvSpPr>
              <p:cNvPr id="408" name="テキスト ボックス 32"/>
              <p:cNvSpPr/>
              <p:nvPr/>
            </p:nvSpPr>
            <p:spPr>
              <a:xfrm>
                <a:off x="7051680" y="4287960"/>
                <a:ext cx="282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09" name="円/楕円 33"/>
              <p:cNvSpPr/>
              <p:nvPr/>
            </p:nvSpPr>
            <p:spPr>
              <a:xfrm>
                <a:off x="7092720" y="4338720"/>
                <a:ext cx="179280" cy="17928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10" name="図形グループ 34"/>
            <p:cNvGrpSpPr/>
            <p:nvPr/>
          </p:nvGrpSpPr>
          <p:grpSpPr>
            <a:xfrm>
              <a:off x="7322760" y="4296240"/>
              <a:ext cx="282960" cy="276480"/>
              <a:chOff x="7322760" y="4296240"/>
              <a:chExt cx="282960" cy="276480"/>
            </a:xfrm>
          </p:grpSpPr>
          <p:sp>
            <p:nvSpPr>
              <p:cNvPr id="411" name="テキスト ボックス 35"/>
              <p:cNvSpPr/>
              <p:nvPr/>
            </p:nvSpPr>
            <p:spPr>
              <a:xfrm>
                <a:off x="7322760" y="4296240"/>
                <a:ext cx="282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2" name="円/楕円 36"/>
              <p:cNvSpPr/>
              <p:nvPr/>
            </p:nvSpPr>
            <p:spPr>
              <a:xfrm>
                <a:off x="7362720" y="4346280"/>
                <a:ext cx="179280" cy="18108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13" name="図形グループ 37"/>
            <p:cNvGrpSpPr/>
            <p:nvPr/>
          </p:nvGrpSpPr>
          <p:grpSpPr>
            <a:xfrm>
              <a:off x="7508880" y="4296240"/>
              <a:ext cx="282960" cy="276480"/>
              <a:chOff x="7508880" y="4296240"/>
              <a:chExt cx="282960" cy="276480"/>
            </a:xfrm>
          </p:grpSpPr>
          <p:sp>
            <p:nvSpPr>
              <p:cNvPr id="414" name="テキスト ボックス 38"/>
              <p:cNvSpPr/>
              <p:nvPr/>
            </p:nvSpPr>
            <p:spPr>
              <a:xfrm>
                <a:off x="7508880" y="4296240"/>
                <a:ext cx="282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P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5" name="円/楕円 39"/>
              <p:cNvSpPr/>
              <p:nvPr/>
            </p:nvSpPr>
            <p:spPr>
              <a:xfrm>
                <a:off x="7557840" y="4354200"/>
                <a:ext cx="179280" cy="18108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416" name="Rectangle 48"/>
          <p:cNvSpPr/>
          <p:nvPr/>
        </p:nvSpPr>
        <p:spPr>
          <a:xfrm>
            <a:off x="134280" y="65160"/>
            <a:ext cx="1720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Suppl Fig 8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17" name="図形グループ 1"/>
          <p:cNvGrpSpPr/>
          <p:nvPr/>
        </p:nvGrpSpPr>
        <p:grpSpPr>
          <a:xfrm>
            <a:off x="1227240" y="601560"/>
            <a:ext cx="7277040" cy="3411720"/>
            <a:chOff x="1227240" y="601560"/>
            <a:chExt cx="7277040" cy="3411720"/>
          </a:xfrm>
        </p:grpSpPr>
        <p:pic>
          <p:nvPicPr>
            <p:cNvPr id="418" name="図 1" descr=""/>
            <p:cNvPicPr/>
            <p:nvPr/>
          </p:nvPicPr>
          <p:blipFill>
            <a:blip r:embed="rId2"/>
            <a:stretch/>
          </p:blipFill>
          <p:spPr>
            <a:xfrm>
              <a:off x="1227240" y="601560"/>
              <a:ext cx="7277040" cy="3411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19" name="Rectangle 3"/>
            <p:cNvSpPr/>
            <p:nvPr/>
          </p:nvSpPr>
          <p:spPr>
            <a:xfrm>
              <a:off x="2921040" y="660240"/>
              <a:ext cx="1912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600" spc="-1" strike="noStrike">
                  <a:solidFill>
                    <a:srgbClr val="000000"/>
                  </a:solidFill>
                  <a:latin typeface="Arial"/>
                  <a:ea typeface="Osaka"/>
                </a:rPr>
                <a:t>MAPT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Osaka"/>
                </a:rPr>
                <a:t>(- AP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0" name="Rectangle 3"/>
            <p:cNvSpPr/>
            <p:nvPr/>
          </p:nvSpPr>
          <p:spPr>
            <a:xfrm>
              <a:off x="6591600" y="660240"/>
              <a:ext cx="1912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600" spc="-1" strike="noStrike">
                  <a:solidFill>
                    <a:srgbClr val="000000"/>
                  </a:solidFill>
                  <a:latin typeface="Arial"/>
                  <a:ea typeface="Osaka"/>
                </a:rPr>
                <a:t>MAPT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Osaka"/>
                </a:rPr>
                <a:t>(+ AP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21" name="Rectangle 42"/>
          <p:cNvSpPr/>
          <p:nvPr/>
        </p:nvSpPr>
        <p:spPr>
          <a:xfrm>
            <a:off x="1079280" y="52560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10T03:38:54Z</dcterms:created>
  <dc:creator>長谷川 成人</dc:creator>
  <dc:description/>
  <dc:language>en-US</dc:language>
  <cp:lastModifiedBy>spsfl3</cp:lastModifiedBy>
  <cp:lastPrinted>2015-07-28T01:30:57Z</cp:lastPrinted>
  <dcterms:modified xsi:type="dcterms:W3CDTF">2015-10-26T10:11:26Z</dcterms:modified>
  <cp:revision>239</cp:revision>
  <dc:subject/>
  <dc:title>PowerPoint プレゼンテーション</dc:title>
</cp:coreProperties>
</file>